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5"/>
  </p:notesMasterIdLst>
  <p:sldIdLst>
    <p:sldId id="313" r:id="rId2"/>
    <p:sldId id="330" r:id="rId3"/>
    <p:sldId id="317" r:id="rId4"/>
    <p:sldId id="318" r:id="rId5"/>
    <p:sldId id="310" r:id="rId6"/>
    <p:sldId id="312" r:id="rId7"/>
    <p:sldId id="315" r:id="rId8"/>
    <p:sldId id="305" r:id="rId9"/>
    <p:sldId id="306" r:id="rId10"/>
    <p:sldId id="322" r:id="rId11"/>
    <p:sldId id="328" r:id="rId12"/>
    <p:sldId id="331" r:id="rId13"/>
    <p:sldId id="323" r:id="rId1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CA1BF"/>
    <a:srgbClr val="072AD9"/>
    <a:srgbClr val="000000"/>
    <a:srgbClr val="CC8D04"/>
    <a:srgbClr val="7FB83E"/>
    <a:srgbClr val="552F8F"/>
    <a:srgbClr val="4560E3"/>
    <a:srgbClr val="03541B"/>
    <a:srgbClr val="AD030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00" autoAdjust="0"/>
    <p:restoredTop sz="95341" autoAdjust="0"/>
  </p:normalViewPr>
  <p:slideViewPr>
    <p:cSldViewPr snapToGrid="0">
      <p:cViewPr varScale="1">
        <p:scale>
          <a:sx n="156" d="100"/>
          <a:sy n="156" d="100"/>
        </p:scale>
        <p:origin x="2088" y="9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aef\plantbreeding\projects\Publications\work%20in%20progress\Beet_population_genomics_RTG\beet_sequencing_main_tables_21.9.2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ni-kiel.de\files\plantbreeding\home\suapp512\Desktop\Beet_NG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Total_SNPs_INDELs!$A$2:$A$10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18-4A86-8088-3E79C61AE29D}"/>
            </c:ext>
          </c:extLst>
        </c:ser>
        <c:ser>
          <c:idx val="1"/>
          <c:order val="1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Total_SNPs_INDELs!$D$2:$D$10</c:f>
              <c:numCache>
                <c:formatCode>#,##0</c:formatCode>
                <c:ptCount val="9"/>
                <c:pt idx="0">
                  <c:v>1254622</c:v>
                </c:pt>
                <c:pt idx="1">
                  <c:v>1147094</c:v>
                </c:pt>
                <c:pt idx="2">
                  <c:v>1214067</c:v>
                </c:pt>
                <c:pt idx="3">
                  <c:v>1344899</c:v>
                </c:pt>
                <c:pt idx="4">
                  <c:v>1520339</c:v>
                </c:pt>
                <c:pt idx="5">
                  <c:v>1458655</c:v>
                </c:pt>
                <c:pt idx="6">
                  <c:v>1239688</c:v>
                </c:pt>
                <c:pt idx="7">
                  <c:v>1351339</c:v>
                </c:pt>
                <c:pt idx="8">
                  <c:v>11222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718-4A86-8088-3E79C61AE2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4718624"/>
        <c:axId val="1864721952"/>
      </c:barChart>
      <c:catAx>
        <c:axId val="18647186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defRPr>
                </a:pPr>
                <a:r>
                  <a:rPr lang="en-GB"/>
                  <a:t>Chromosome number</a:t>
                </a:r>
              </a:p>
            </c:rich>
          </c:tx>
          <c:layout>
            <c:manualLayout>
              <c:xMode val="edge"/>
              <c:yMode val="edge"/>
              <c:x val="0.46574675100930163"/>
              <c:y val="0.963294366029020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defRPr>
              </a:pPr>
              <a:endParaRPr lang="de-DE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defRPr>
            </a:pPr>
            <a:endParaRPr lang="de-DE"/>
          </a:p>
        </c:txPr>
        <c:crossAx val="1864721952"/>
        <c:crosses val="autoZero"/>
        <c:auto val="1"/>
        <c:lblAlgn val="ctr"/>
        <c:lblOffset val="100"/>
        <c:noMultiLvlLbl val="0"/>
      </c:catAx>
      <c:valAx>
        <c:axId val="1864721952"/>
        <c:scaling>
          <c:orientation val="minMax"/>
          <c:max val="16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defRPr>
                </a:pPr>
                <a:r>
                  <a:rPr lang="en-GB"/>
                  <a:t>Number of variants</a:t>
                </a:r>
              </a:p>
            </c:rich>
          </c:tx>
          <c:layout>
            <c:manualLayout>
              <c:xMode val="edge"/>
              <c:yMode val="edge"/>
              <c:x val="1.7861256571746981E-3"/>
              <c:y val="0.345646480594449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defRPr>
            </a:pPr>
            <a:endParaRPr lang="de-DE"/>
          </a:p>
        </c:txPr>
        <c:crossAx val="1864718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Microsoft Sans Serif" panose="020B0604020202020204" pitchFamily="34" charset="0"/>
          <a:ea typeface="Microsoft Sans Serif" panose="020B0604020202020204" pitchFamily="34" charset="0"/>
          <a:cs typeface="Microsoft Sans Serif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6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GB" dirty="0"/>
              <a:t>Fodder beet</a:t>
            </a:r>
          </a:p>
          <a:p>
            <a:pPr>
              <a:defRPr/>
            </a:pPr>
            <a:r>
              <a:rPr lang="en-GB" dirty="0"/>
              <a:t>Average Heterozygosity: 21.09%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6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46A-4E1F-A59A-13D8C6C5C8A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46A-4E1F-A59A-13D8C6C5C8A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46A-4E1F-A59A-13D8C6C5C8AA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46A-4E1F-A59A-13D8C6C5C8AA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46A-4E1F-A59A-13D8C6C5C8AA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346A-4E1F-A59A-13D8C6C5C8A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D$2:$D$7</c:f>
              <c:numCache>
                <c:formatCode>General</c:formatCode>
                <c:ptCount val="6"/>
                <c:pt idx="0">
                  <c:v>0</c:v>
                </c:pt>
                <c:pt idx="1">
                  <c:v>6</c:v>
                </c:pt>
                <c:pt idx="2">
                  <c:v>5</c:v>
                </c:pt>
                <c:pt idx="3">
                  <c:v>12</c:v>
                </c:pt>
                <c:pt idx="4">
                  <c:v>6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346A-4E1F-A59A-13D8C6C5C8A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0"/>
        <c:overlap val="-27"/>
        <c:axId val="1321270063"/>
        <c:axId val="1321263823"/>
      </c:barChart>
      <c:catAx>
        <c:axId val="1321270063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21263823"/>
        <c:crosses val="autoZero"/>
        <c:auto val="1"/>
        <c:lblAlgn val="ctr"/>
        <c:lblOffset val="100"/>
        <c:noMultiLvlLbl val="0"/>
      </c:catAx>
      <c:valAx>
        <c:axId val="1321263823"/>
        <c:scaling>
          <c:orientation val="minMax"/>
          <c:max val="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13212700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GB" sz="1260" dirty="0"/>
              <a:t>Table beet</a:t>
            </a:r>
          </a:p>
          <a:p>
            <a:pPr>
              <a:defRPr/>
            </a:pPr>
            <a:r>
              <a:rPr lang="en-GB" sz="1260" dirty="0"/>
              <a:t>Average Heterozygosity: 19.77%</a:t>
            </a:r>
          </a:p>
        </c:rich>
      </c:tx>
      <c:layout>
        <c:manualLayout>
          <c:xMode val="edge"/>
          <c:yMode val="edge"/>
          <c:x val="0.13096622358093626"/>
          <c:y val="3.27564557514876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B10-4653-ACD4-FF1B43911827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B10-4653-ACD4-FF1B4391182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B10-4653-ACD4-FF1B4391182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B10-4653-ACD4-FF1B43911827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B10-4653-ACD4-FF1B43911827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B10-4653-ACD4-FF1B4391182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E$2:$E$7</c:f>
              <c:numCache>
                <c:formatCode>General</c:formatCode>
                <c:ptCount val="6"/>
                <c:pt idx="0">
                  <c:v>6</c:v>
                </c:pt>
                <c:pt idx="1">
                  <c:v>6</c:v>
                </c:pt>
                <c:pt idx="2">
                  <c:v>15</c:v>
                </c:pt>
                <c:pt idx="3">
                  <c:v>20</c:v>
                </c:pt>
                <c:pt idx="4">
                  <c:v>10</c:v>
                </c:pt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DB10-4653-ACD4-FF1B4391182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0"/>
        <c:overlap val="-27"/>
        <c:axId val="1330542063"/>
        <c:axId val="1330542479"/>
      </c:barChart>
      <c:catAx>
        <c:axId val="1330542063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30542479"/>
        <c:crosses val="autoZero"/>
        <c:auto val="1"/>
        <c:lblAlgn val="ctr"/>
        <c:lblOffset val="100"/>
        <c:noMultiLvlLbl val="0"/>
      </c:catAx>
      <c:valAx>
        <c:axId val="1330542479"/>
        <c:scaling>
          <c:orientation val="minMax"/>
          <c:max val="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13305420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GB" sz="1260" dirty="0"/>
              <a:t>Leaf beet</a:t>
            </a:r>
          </a:p>
          <a:p>
            <a:pPr>
              <a:defRPr/>
            </a:pPr>
            <a:r>
              <a:rPr lang="en-GB" sz="1260" dirty="0"/>
              <a:t>Average Heterozygosity: 21.97%</a:t>
            </a:r>
          </a:p>
        </c:rich>
      </c:tx>
      <c:layout>
        <c:manualLayout>
          <c:xMode val="edge"/>
          <c:yMode val="edge"/>
          <c:x val="0.11978168724455003"/>
          <c:y val="3.27564557514876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193-4E67-8289-C3329B274E48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193-4E67-8289-C3329B274E48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193-4E67-8289-C3329B274E48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193-4E67-8289-C3329B274E48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193-4E67-8289-C3329B274E48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1193-4E67-8289-C3329B274E4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F$2:$F$7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2</c:v>
                </c:pt>
                <c:pt idx="3">
                  <c:v>12</c:v>
                </c:pt>
                <c:pt idx="4">
                  <c:v>6</c:v>
                </c:pt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1193-4E67-8289-C3329B274E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1343979743"/>
        <c:axId val="1343985151"/>
      </c:barChart>
      <c:catAx>
        <c:axId val="1343979743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43985151"/>
        <c:crosses val="autoZero"/>
        <c:auto val="1"/>
        <c:lblAlgn val="ctr"/>
        <c:lblOffset val="100"/>
        <c:noMultiLvlLbl val="0"/>
      </c:catAx>
      <c:valAx>
        <c:axId val="1343985151"/>
        <c:scaling>
          <c:orientation val="minMax"/>
          <c:max val="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1343979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de-DE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US" sz="1260" dirty="0"/>
              <a:t>Mediterranean </a:t>
            </a:r>
            <a:r>
              <a:rPr lang="en-GB" sz="1260" dirty="0"/>
              <a:t>sea beet</a:t>
            </a:r>
            <a:endParaRPr lang="en-GB" sz="1260" i="1" dirty="0"/>
          </a:p>
          <a:p>
            <a:pPr>
              <a:defRPr/>
            </a:pPr>
            <a:r>
              <a:rPr lang="en-GB" sz="1260" dirty="0"/>
              <a:t>Average Heterozygosity: 22.89%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BB7-4864-9B63-3C32A14466DF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BB7-4864-9B63-3C32A14466DF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BB7-4864-9B63-3C32A14466DF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BB7-4864-9B63-3C32A14466DF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BB7-4864-9B63-3C32A14466DF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BB7-4864-9B63-3C32A14466DF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G$2:$G$7</c:f>
              <c:numCache>
                <c:formatCode>General</c:formatCode>
                <c:ptCount val="6"/>
                <c:pt idx="0">
                  <c:v>1</c:v>
                </c:pt>
                <c:pt idx="1">
                  <c:v>7</c:v>
                </c:pt>
                <c:pt idx="2">
                  <c:v>9</c:v>
                </c:pt>
                <c:pt idx="3">
                  <c:v>28</c:v>
                </c:pt>
                <c:pt idx="4">
                  <c:v>18</c:v>
                </c:pt>
                <c:pt idx="5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BB7-4864-9B63-3C32A14466D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0"/>
        <c:overlap val="-27"/>
        <c:axId val="1352189295"/>
        <c:axId val="1352189711"/>
      </c:barChart>
      <c:catAx>
        <c:axId val="1352189295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52189711"/>
        <c:crosses val="autoZero"/>
        <c:auto val="1"/>
        <c:lblAlgn val="ctr"/>
        <c:lblOffset val="100"/>
        <c:noMultiLvlLbl val="0"/>
      </c:catAx>
      <c:valAx>
        <c:axId val="1352189711"/>
        <c:scaling>
          <c:orientation val="minMax"/>
          <c:max val="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13521892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de-DE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GB" sz="1260" dirty="0"/>
              <a:t>Atlantic sea beet</a:t>
            </a:r>
            <a:endParaRPr lang="en-GB" sz="1260" i="1" dirty="0"/>
          </a:p>
          <a:p>
            <a:pPr>
              <a:defRPr/>
            </a:pPr>
            <a:r>
              <a:rPr lang="en-GB" sz="1260" dirty="0"/>
              <a:t>Average Heterozygosity: 19:34%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D18-4379-BFC8-B010FEF79F7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D18-4379-BFC8-B010FEF79F7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D18-4379-BFC8-B010FEF79F7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D18-4379-BFC8-B010FEF79F74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D18-4379-BFC8-B010FEF79F7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D18-4379-BFC8-B010FEF79F7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H$2:$H$7</c:f>
              <c:numCache>
                <c:formatCode>General</c:formatCode>
                <c:ptCount val="6"/>
                <c:pt idx="0">
                  <c:v>2</c:v>
                </c:pt>
                <c:pt idx="1">
                  <c:v>2</c:v>
                </c:pt>
                <c:pt idx="2">
                  <c:v>10</c:v>
                </c:pt>
                <c:pt idx="3">
                  <c:v>4</c:v>
                </c:pt>
                <c:pt idx="4">
                  <c:v>3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8D18-4379-BFC8-B010FEF79F7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0"/>
        <c:overlap val="-27"/>
        <c:axId val="1317072975"/>
        <c:axId val="1317062575"/>
      </c:barChart>
      <c:catAx>
        <c:axId val="1317072975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17062575"/>
        <c:crosses val="autoZero"/>
        <c:auto val="1"/>
        <c:lblAlgn val="ctr"/>
        <c:lblOffset val="100"/>
        <c:noMultiLvlLbl val="0"/>
      </c:catAx>
      <c:valAx>
        <c:axId val="1317062575"/>
        <c:scaling>
          <c:orientation val="minMax"/>
          <c:max val="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13170729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de-DE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r>
              <a:rPr lang="en-GB" sz="1260" dirty="0"/>
              <a:t>Sugar beet</a:t>
            </a:r>
          </a:p>
          <a:p>
            <a:pPr>
              <a:defRPr/>
            </a:pPr>
            <a:r>
              <a:rPr lang="en-GB" sz="1260" dirty="0"/>
              <a:t>Average Heterozygosity: 20.24%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Sanf"/>
              <a:ea typeface="+mn-ea"/>
              <a:cs typeface="Times New Roman" panose="02020603050405020304" pitchFamily="18" charset="0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F32-4F05-B759-76054439FF75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F32-4F05-B759-76054439FF7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F32-4F05-B759-76054439FF75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F32-4F05-B759-76054439FF75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F32-4F05-B759-76054439FF75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F32-4F05-B759-76054439FF75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Sanf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heet5!$C$2:$C$7</c:f>
              <c:numCache>
                <c:formatCode>General</c:formatCode>
                <c:ptCount val="6"/>
                <c:pt idx="0" formatCode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cat>
          <c:val>
            <c:numRef>
              <c:f>Sheet5!$I$2:$I$7</c:f>
              <c:numCache>
                <c:formatCode>General</c:formatCode>
                <c:ptCount val="6"/>
                <c:pt idx="0">
                  <c:v>9</c:v>
                </c:pt>
                <c:pt idx="1">
                  <c:v>11</c:v>
                </c:pt>
                <c:pt idx="2">
                  <c:v>11</c:v>
                </c:pt>
                <c:pt idx="3">
                  <c:v>29</c:v>
                </c:pt>
                <c:pt idx="4">
                  <c:v>17</c:v>
                </c:pt>
                <c:pt idx="5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F32-4F05-B759-76054439FF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1343989311"/>
        <c:axId val="1343993055"/>
      </c:barChart>
      <c:catAx>
        <c:axId val="1343989311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1343993055"/>
        <c:crosses val="autoZero"/>
        <c:auto val="1"/>
        <c:lblAlgn val="ctr"/>
        <c:lblOffset val="100"/>
        <c:noMultiLvlLbl val="0"/>
      </c:catAx>
      <c:valAx>
        <c:axId val="1343993055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Sanf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13439893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Sanf"/>
          <a:cs typeface="Times New Roman" panose="02020603050405020304" pitchFamily="18" charset="0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EA11FC-5D7C-3047-84CF-B441F7B616F0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4AE58-BA85-C94F-B696-CD0696F33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6997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84AE58-BA85-C94F-B696-CD0696F3354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0492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1B2116-D8EF-C342-A97F-33511E48A082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4976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F20B50-0D12-514A-8D81-99D2A5B90B4B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838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56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646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300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271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247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401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347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276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44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947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937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53A20-E338-C245-AB24-3BA7C5F8B1C4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33CE5-F499-5A41-B339-76089C1093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986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em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7" Type="http://schemas.openxmlformats.org/officeDocument/2006/relationships/chart" Target="../charts/chart7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4114215"/>
              </p:ext>
            </p:extLst>
          </p:nvPr>
        </p:nvGraphicFramePr>
        <p:xfrm>
          <a:off x="728302" y="1886261"/>
          <a:ext cx="8349023" cy="3781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40822" y="99781"/>
            <a:ext cx="67358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Fig. S1</a:t>
            </a:r>
          </a:p>
        </p:txBody>
      </p:sp>
    </p:spTree>
    <p:extLst>
      <p:ext uri="{BB962C8B-B14F-4D97-AF65-F5344CB8AC3E}">
        <p14:creationId xmlns:p14="http://schemas.microsoft.com/office/powerpoint/2010/main" val="22459378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114300" y="56192"/>
            <a:ext cx="768159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Fig. S10</a:t>
            </a:r>
          </a:p>
        </p:txBody>
      </p:sp>
      <p:grpSp>
        <p:nvGrpSpPr>
          <p:cNvPr id="25" name="Group 24"/>
          <p:cNvGrpSpPr/>
          <p:nvPr/>
        </p:nvGrpSpPr>
        <p:grpSpPr>
          <a:xfrm>
            <a:off x="738554" y="894436"/>
            <a:ext cx="3787337" cy="2634209"/>
            <a:chOff x="2348441" y="0"/>
            <a:chExt cx="4407871" cy="3187153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AB845D7-10CB-99C7-474B-A426A16220CB}"/>
                </a:ext>
              </a:extLst>
            </p:cNvPr>
            <p:cNvSpPr txBox="1"/>
            <p:nvPr/>
          </p:nvSpPr>
          <p:spPr>
            <a:xfrm>
              <a:off x="3129856" y="0"/>
              <a:ext cx="3438660" cy="321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cap="all" dirty="0">
                  <a:latin typeface="Arial" panose="020B0604020202020204" pitchFamily="34" charset="0"/>
                  <a:cs typeface="Arial" panose="020B0604020202020204" pitchFamily="34" charset="0"/>
                </a:rPr>
                <a:t>Inositol transporter 1</a:t>
              </a:r>
            </a:p>
          </p:txBody>
        </p: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B024B72F-6DD7-DEB4-7C1B-3F5E4A0E17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465" r="9659"/>
            <a:stretch/>
          </p:blipFill>
          <p:spPr>
            <a:xfrm>
              <a:off x="2500621" y="655686"/>
              <a:ext cx="4255691" cy="2531467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2348441" y="0"/>
              <a:ext cx="502908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691662" y="3712813"/>
            <a:ext cx="3871377" cy="2590892"/>
            <a:chOff x="2348441" y="3468769"/>
            <a:chExt cx="4453591" cy="3188791"/>
          </a:xfrm>
        </p:grpSpPr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1D4AA0DA-64E7-8271-1139-C13D94ADE1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651" r="8977"/>
            <a:stretch/>
          </p:blipFill>
          <p:spPr>
            <a:xfrm>
              <a:off x="2500621" y="4122993"/>
              <a:ext cx="4301411" cy="2534567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BB9271E-44BD-C4FE-63C3-A3F2E9B95E2D}"/>
                </a:ext>
              </a:extLst>
            </p:cNvPr>
            <p:cNvSpPr txBox="1"/>
            <p:nvPr/>
          </p:nvSpPr>
          <p:spPr>
            <a:xfrm>
              <a:off x="2937028" y="3470407"/>
              <a:ext cx="3438659" cy="321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cap="all" dirty="0">
                  <a:latin typeface="Arial" panose="020B0604020202020204" pitchFamily="34" charset="0"/>
                  <a:cs typeface="Arial" panose="020B0604020202020204" pitchFamily="34" charset="0"/>
                </a:rPr>
                <a:t>Raffinose Synthase 5</a:t>
              </a:r>
              <a:r>
                <a:rPr lang="en-US" sz="1100" b="1" cap="all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RS5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348441" y="3468769"/>
              <a:ext cx="502908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5041919" y="820615"/>
            <a:ext cx="3779696" cy="2621507"/>
            <a:chOff x="7627887" y="374070"/>
            <a:chExt cx="4355776" cy="3062731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BDB00E6D-5F49-3650-F6B6-60D3EDA96B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078" r="9542"/>
            <a:stretch/>
          </p:blipFill>
          <p:spPr>
            <a:xfrm>
              <a:off x="7727972" y="898402"/>
              <a:ext cx="4255691" cy="2538399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24153CF-09F2-84A1-8FB4-DC1AAA51AA54}"/>
                </a:ext>
              </a:extLst>
            </p:cNvPr>
            <p:cNvSpPr txBox="1"/>
            <p:nvPr/>
          </p:nvSpPr>
          <p:spPr>
            <a:xfrm>
              <a:off x="8270451" y="374070"/>
              <a:ext cx="2849553" cy="314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cap="all" dirty="0">
                  <a:latin typeface="Arial" panose="020B0604020202020204" pitchFamily="34" charset="0"/>
                  <a:cs typeface="Arial" panose="020B0604020202020204" pitchFamily="34" charset="0"/>
                </a:rPr>
                <a:t>Flowering locus C </a:t>
              </a:r>
              <a:r>
                <a:rPr lang="en-US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(FLC)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627887" y="384686"/>
              <a:ext cx="502908" cy="295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5041919" y="3681029"/>
            <a:ext cx="4285987" cy="2606070"/>
            <a:chOff x="7505700" y="3672537"/>
            <a:chExt cx="5026529" cy="2993332"/>
          </a:xfrm>
        </p:grpSpPr>
        <p:grpSp>
          <p:nvGrpSpPr>
            <p:cNvPr id="47" name="Group 46"/>
            <p:cNvGrpSpPr/>
            <p:nvPr/>
          </p:nvGrpSpPr>
          <p:grpSpPr>
            <a:xfrm>
              <a:off x="7505700" y="3672537"/>
              <a:ext cx="5026529" cy="354807"/>
              <a:chOff x="7627887" y="3727178"/>
              <a:chExt cx="5026529" cy="354807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CAE6EE07-48E3-A5BC-ADE8-50FB42DD1D6A}"/>
                  </a:ext>
                </a:extLst>
              </p:cNvPr>
              <p:cNvSpPr txBox="1"/>
              <p:nvPr/>
            </p:nvSpPr>
            <p:spPr>
              <a:xfrm>
                <a:off x="7716801" y="3760002"/>
                <a:ext cx="4937615" cy="3219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b="1" i="1" dirty="0">
                    <a:latin typeface="Sanf"/>
                  </a:rPr>
                  <a:t>SUPPRESSOR OF OVEREXPRESSION OF CO 1</a:t>
                </a:r>
                <a:endParaRPr lang="en-US" sz="1100" b="1" i="1" dirty="0">
                  <a:latin typeface="Sanf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7627887" y="3727178"/>
                <a:ext cx="502908" cy="2983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75" b="1" dirty="0">
                    <a:latin typeface="Sanf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D</a:t>
                </a:r>
              </a:p>
            </p:txBody>
          </p:sp>
        </p:grpSp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313BDD6E-437B-0910-2737-0CA3206631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3946" r="8684"/>
            <a:stretch/>
          </p:blipFill>
          <p:spPr>
            <a:xfrm>
              <a:off x="7505700" y="4131302"/>
              <a:ext cx="4342265" cy="253456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07942251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0" y="103863"/>
            <a:ext cx="768159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Fig. S11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920262" y="3563815"/>
            <a:ext cx="3779483" cy="2655898"/>
            <a:chOff x="2606230" y="3659367"/>
            <a:chExt cx="4364673" cy="301315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0FA3190-3552-36B1-3A06-3A7460E7C5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465" r="9377"/>
            <a:stretch/>
          </p:blipFill>
          <p:spPr>
            <a:xfrm>
              <a:off x="2715212" y="4148957"/>
              <a:ext cx="4255691" cy="2523563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D4C8718-4B38-75AA-505C-3BB8C0E5EBB0}"/>
                </a:ext>
              </a:extLst>
            </p:cNvPr>
            <p:cNvSpPr txBox="1"/>
            <p:nvPr/>
          </p:nvSpPr>
          <p:spPr>
            <a:xfrm>
              <a:off x="3404919" y="3659367"/>
              <a:ext cx="2849552" cy="310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erpene synthase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606230" y="3659367"/>
              <a:ext cx="502908" cy="292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920262" y="709247"/>
            <a:ext cx="3779483" cy="2697678"/>
            <a:chOff x="2568614" y="292879"/>
            <a:chExt cx="4402289" cy="3143922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CB372D95-0345-529C-129B-469D64FC82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499" r="9409"/>
            <a:stretch/>
          </p:blipFill>
          <p:spPr>
            <a:xfrm>
              <a:off x="2715212" y="913238"/>
              <a:ext cx="4255691" cy="2523563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07CFAA2-74B2-0531-406E-A54752195639}"/>
                </a:ext>
              </a:extLst>
            </p:cNvPr>
            <p:cNvSpPr txBox="1"/>
            <p:nvPr/>
          </p:nvSpPr>
          <p:spPr>
            <a:xfrm>
              <a:off x="3388960" y="301189"/>
              <a:ext cx="2849553" cy="321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erpene synthase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568614" y="292879"/>
              <a:ext cx="502909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25" name="Group 5">
            <a:extLst>
              <a:ext uri="{FF2B5EF4-FFF2-40B4-BE49-F238E27FC236}">
                <a16:creationId xmlns:a16="http://schemas.microsoft.com/office/drawing/2014/main" id="{C70BF4DA-9928-451A-A41A-6DE1D8E0C43A}"/>
              </a:ext>
            </a:extLst>
          </p:cNvPr>
          <p:cNvGrpSpPr/>
          <p:nvPr/>
        </p:nvGrpSpPr>
        <p:grpSpPr>
          <a:xfrm>
            <a:off x="5219436" y="764179"/>
            <a:ext cx="3901679" cy="2685530"/>
            <a:chOff x="1428750" y="654485"/>
            <a:chExt cx="5838825" cy="4050865"/>
          </a:xfrm>
        </p:grpSpPr>
        <p:pic>
          <p:nvPicPr>
            <p:cNvPr id="26" name="Picture 2">
              <a:extLst>
                <a:ext uri="{FF2B5EF4-FFF2-40B4-BE49-F238E27FC236}">
                  <a16:creationId xmlns:a16="http://schemas.microsoft.com/office/drawing/2014/main" id="{FA5D6100-D54B-4EA9-B5D7-6C7BD355F82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4074" r="9379"/>
            <a:stretch>
              <a:fillRect/>
            </a:stretch>
          </p:blipFill>
          <p:spPr>
            <a:xfrm>
              <a:off x="1428750" y="1228725"/>
              <a:ext cx="5838825" cy="3476625"/>
            </a:xfrm>
            <a:prstGeom prst="rect">
              <a:avLst/>
            </a:prstGeom>
          </p:spPr>
        </p:pic>
        <p:sp>
          <p:nvSpPr>
            <p:cNvPr id="34" name="TextBox 4">
              <a:extLst>
                <a:ext uri="{FF2B5EF4-FFF2-40B4-BE49-F238E27FC236}">
                  <a16:creationId xmlns:a16="http://schemas.microsoft.com/office/drawing/2014/main" id="{696A0598-175B-4899-8A4B-87DD4CE0C65B}"/>
                </a:ext>
              </a:extLst>
            </p:cNvPr>
            <p:cNvSpPr txBox="1"/>
            <p:nvPr/>
          </p:nvSpPr>
          <p:spPr>
            <a:xfrm>
              <a:off x="1864292" y="654485"/>
              <a:ext cx="4967740" cy="3946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WUSCHEL-RELATED HOMEOBOX 4 (WOX4)</a:t>
              </a:r>
            </a:p>
          </p:txBody>
        </p:sp>
      </p:grpSp>
      <p:sp>
        <p:nvSpPr>
          <p:cNvPr id="36" name="TextBox 10">
            <a:extLst>
              <a:ext uri="{FF2B5EF4-FFF2-40B4-BE49-F238E27FC236}">
                <a16:creationId xmlns:a16="http://schemas.microsoft.com/office/drawing/2014/main" id="{C980D65B-4835-4909-9E75-09991572A3F4}"/>
              </a:ext>
            </a:extLst>
          </p:cNvPr>
          <p:cNvSpPr txBox="1"/>
          <p:nvPr/>
        </p:nvSpPr>
        <p:spPr>
          <a:xfrm>
            <a:off x="5002869" y="696862"/>
            <a:ext cx="4331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74084662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8534E69-9446-AD7C-2184-1DC96A0EC10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245" b="32143"/>
          <a:stretch/>
        </p:blipFill>
        <p:spPr>
          <a:xfrm>
            <a:off x="1940169" y="646788"/>
            <a:ext cx="4597791" cy="5828084"/>
          </a:xfrm>
          <a:prstGeom prst="rect">
            <a:avLst/>
          </a:prstGeom>
        </p:spPr>
      </p:pic>
      <p:sp>
        <p:nvSpPr>
          <p:cNvPr id="3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93889" y="26302"/>
            <a:ext cx="768159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Fig. S12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6573338" y="3800487"/>
            <a:ext cx="2675437" cy="1200330"/>
            <a:chOff x="10169301" y="5282175"/>
            <a:chExt cx="2614674" cy="818229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8CA8C4E-6049-3253-37C2-727E287A03B8}"/>
                </a:ext>
              </a:extLst>
            </p:cNvPr>
            <p:cNvSpPr txBox="1"/>
            <p:nvPr/>
          </p:nvSpPr>
          <p:spPr>
            <a:xfrm>
              <a:off x="10461988" y="5282175"/>
              <a:ext cx="2321987" cy="818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AD0209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Table beet</a:t>
              </a:r>
            </a:p>
            <a:p>
              <a:r>
                <a:rPr lang="en-US" sz="1200" dirty="0">
                  <a:solidFill>
                    <a:srgbClr val="04541A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Sugar beet</a:t>
              </a:r>
              <a:endParaRPr lang="en-US" sz="1200" dirty="0">
                <a:solidFill>
                  <a:srgbClr val="4A0058"/>
                </a:solidFill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dirty="0">
                  <a:solidFill>
                    <a:srgbClr val="072AD9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Mediterranean sea beet</a:t>
              </a:r>
            </a:p>
            <a:p>
              <a:r>
                <a:rPr lang="en-US" sz="1200" dirty="0">
                  <a:solidFill>
                    <a:srgbClr val="4A0058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Atlantic sea beet</a:t>
              </a:r>
            </a:p>
            <a:p>
              <a:r>
                <a:rPr lang="en-US" sz="1200" dirty="0">
                  <a:solidFill>
                    <a:srgbClr val="7FB83E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Leaf beet</a:t>
              </a:r>
              <a:endParaRPr lang="en-US" sz="1200" dirty="0">
                <a:solidFill>
                  <a:srgbClr val="0075DD"/>
                </a:solidFill>
                <a:latin typeface="Arial" panose="020B0604020202020204" pitchFamily="34" charset="0"/>
                <a:ea typeface="Microsoft Sans Serif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dirty="0">
                  <a:solidFill>
                    <a:srgbClr val="CC8D04"/>
                  </a:solidFill>
                  <a:latin typeface="Arial" panose="020B0604020202020204" pitchFamily="34" charset="0"/>
                  <a:ea typeface="Microsoft Sans Serif" panose="020B0604020202020204" pitchFamily="34" charset="0"/>
                  <a:cs typeface="Arial" panose="020B0604020202020204" pitchFamily="34" charset="0"/>
                </a:rPr>
                <a:t>Fodder beet</a:t>
              </a: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10169301" y="5369511"/>
              <a:ext cx="253430" cy="0"/>
            </a:xfrm>
            <a:prstGeom prst="line">
              <a:avLst/>
            </a:prstGeom>
            <a:ln w="19050">
              <a:solidFill>
                <a:srgbClr val="AD030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10169301" y="5518815"/>
              <a:ext cx="253430" cy="0"/>
            </a:xfrm>
            <a:prstGeom prst="line">
              <a:avLst/>
            </a:prstGeom>
            <a:ln w="19050">
              <a:solidFill>
                <a:srgbClr val="03541B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10169301" y="5637083"/>
              <a:ext cx="253430" cy="0"/>
            </a:xfrm>
            <a:prstGeom prst="line">
              <a:avLst/>
            </a:prstGeom>
            <a:ln w="19050">
              <a:solidFill>
                <a:srgbClr val="072AD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10169301" y="5770004"/>
              <a:ext cx="253430" cy="0"/>
            </a:xfrm>
            <a:prstGeom prst="line">
              <a:avLst/>
            </a:prstGeom>
            <a:ln w="19050">
              <a:solidFill>
                <a:srgbClr val="552F8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10169301" y="5891671"/>
              <a:ext cx="253430" cy="0"/>
            </a:xfrm>
            <a:prstGeom prst="line">
              <a:avLst/>
            </a:prstGeom>
            <a:ln w="19050">
              <a:solidFill>
                <a:srgbClr val="7FB83E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10169301" y="6044070"/>
              <a:ext cx="253430" cy="0"/>
            </a:xfrm>
            <a:prstGeom prst="line">
              <a:avLst/>
            </a:prstGeom>
            <a:ln w="19050">
              <a:solidFill>
                <a:srgbClr val="CC8D0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2641525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1132900"/>
            <a:ext cx="9902288" cy="4547368"/>
            <a:chOff x="16716" y="501431"/>
            <a:chExt cx="12187432" cy="5596760"/>
          </a:xfrm>
        </p:grpSpPr>
        <p:grpSp>
          <p:nvGrpSpPr>
            <p:cNvPr id="4" name="Group 3"/>
            <p:cNvGrpSpPr/>
            <p:nvPr/>
          </p:nvGrpSpPr>
          <p:grpSpPr>
            <a:xfrm>
              <a:off x="16716" y="501431"/>
              <a:ext cx="9596843" cy="4788710"/>
              <a:chOff x="897593" y="-196472"/>
              <a:chExt cx="11645809" cy="4896008"/>
            </a:xfrm>
          </p:grpSpPr>
          <p:sp>
            <p:nvSpPr>
              <p:cNvPr id="5" name="Rounded Rectangle 4"/>
              <p:cNvSpPr/>
              <p:nvPr/>
            </p:nvSpPr>
            <p:spPr>
              <a:xfrm>
                <a:off x="932511" y="826341"/>
                <a:ext cx="1487815" cy="825646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ference genome EL10.2</a:t>
                </a: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897593" y="3340402"/>
                <a:ext cx="1522732" cy="457210"/>
              </a:xfrm>
              <a:prstGeom prst="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w reads </a:t>
                </a:r>
              </a:p>
            </p:txBody>
          </p:sp>
          <p:pic>
            <p:nvPicPr>
              <p:cNvPr id="7" name="Picture 14" descr="https://www.abmgood.com/marketing/knowledge_base/img/NGS/Next_Generation_Sequencing_NGS_rainbow-sequence.png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29731" b="40539"/>
              <a:stretch/>
            </p:blipFill>
            <p:spPr bwMode="auto">
              <a:xfrm>
                <a:off x="913149" y="2866946"/>
                <a:ext cx="1490540" cy="44807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8" name="Straight Connector 7"/>
              <p:cNvCxnSpPr>
                <a:cxnSpLocks/>
              </p:cNvCxnSpPr>
              <p:nvPr/>
            </p:nvCxnSpPr>
            <p:spPr>
              <a:xfrm>
                <a:off x="1658419" y="1589691"/>
                <a:ext cx="18000" cy="129605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Arrow Connector 8"/>
              <p:cNvCxnSpPr/>
              <p:nvPr/>
            </p:nvCxnSpPr>
            <p:spPr>
              <a:xfrm>
                <a:off x="1655829" y="2219295"/>
                <a:ext cx="118807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Oval 9"/>
              <p:cNvSpPr/>
              <p:nvPr/>
            </p:nvSpPr>
            <p:spPr>
              <a:xfrm>
                <a:off x="2858100" y="1662097"/>
                <a:ext cx="1333499" cy="111439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WA-MEM</a:t>
                </a:r>
              </a:p>
            </p:txBody>
          </p:sp>
          <p:sp>
            <p:nvSpPr>
              <p:cNvPr id="11" name="Rectangle 10"/>
              <p:cNvSpPr/>
              <p:nvPr/>
            </p:nvSpPr>
            <p:spPr>
              <a:xfrm>
                <a:off x="897593" y="-196068"/>
                <a:ext cx="5687757" cy="457210"/>
              </a:xfrm>
              <a:prstGeom prst="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hort read alignment</a:t>
                </a: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>
                <a:off x="3494154" y="847695"/>
                <a:ext cx="118807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>
                <a:off x="3496744" y="840925"/>
                <a:ext cx="0" cy="80858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Rounded Rectangle 13"/>
              <p:cNvSpPr/>
              <p:nvPr/>
            </p:nvSpPr>
            <p:spPr>
              <a:xfrm>
                <a:off x="4761561" y="504289"/>
                <a:ext cx="1487815" cy="673272"/>
              </a:xfrm>
              <a:prstGeom prst="round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GB" sz="1100" b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m</a:t>
                </a:r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files</a:t>
                </a: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>
                <a:off x="5503947" y="1215764"/>
                <a:ext cx="1521" cy="5334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Rounded Rectangle 15"/>
              <p:cNvSpPr/>
              <p:nvPr/>
            </p:nvSpPr>
            <p:spPr>
              <a:xfrm>
                <a:off x="4760038" y="1769399"/>
                <a:ext cx="1487815" cy="673272"/>
              </a:xfrm>
              <a:prstGeom prst="round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.bam files</a:t>
                </a:r>
              </a:p>
            </p:txBody>
          </p:sp>
          <p:sp>
            <p:nvSpPr>
              <p:cNvPr id="17" name="Rounded Rectangle 16"/>
              <p:cNvSpPr/>
              <p:nvPr/>
            </p:nvSpPr>
            <p:spPr>
              <a:xfrm>
                <a:off x="4760038" y="3050968"/>
                <a:ext cx="1487815" cy="772147"/>
              </a:xfrm>
              <a:prstGeom prst="round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alysis ready alignment</a:t>
                </a: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>
                <a:off x="5503946" y="2488418"/>
                <a:ext cx="1521" cy="5334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/>
              <p:cNvCxnSpPr/>
              <p:nvPr/>
            </p:nvCxnSpPr>
            <p:spPr>
              <a:xfrm>
                <a:off x="6250719" y="3389986"/>
                <a:ext cx="344143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>
                <a:off x="6594862" y="852307"/>
                <a:ext cx="0" cy="253767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Arrow Connector 20"/>
              <p:cNvCxnSpPr/>
              <p:nvPr/>
            </p:nvCxnSpPr>
            <p:spPr>
              <a:xfrm>
                <a:off x="6585350" y="847695"/>
                <a:ext cx="118807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Rectangle 21"/>
              <p:cNvSpPr/>
              <p:nvPr/>
            </p:nvSpPr>
            <p:spPr>
              <a:xfrm>
                <a:off x="6585350" y="-196068"/>
                <a:ext cx="3223108" cy="457210"/>
              </a:xfrm>
              <a:prstGeom prst="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e-processing</a:t>
                </a:r>
              </a:p>
            </p:txBody>
          </p:sp>
          <p:sp>
            <p:nvSpPr>
              <p:cNvPr id="23" name="Rounded Rectangle 22"/>
              <p:cNvSpPr/>
              <p:nvPr/>
            </p:nvSpPr>
            <p:spPr>
              <a:xfrm>
                <a:off x="7846703" y="447676"/>
                <a:ext cx="1487815" cy="673272"/>
              </a:xfrm>
              <a:prstGeom prst="round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arking duplicates</a:t>
                </a:r>
              </a:p>
            </p:txBody>
          </p:sp>
          <p:cxnSp>
            <p:nvCxnSpPr>
              <p:cNvPr id="24" name="Straight Arrow Connector 23"/>
              <p:cNvCxnSpPr/>
              <p:nvPr/>
            </p:nvCxnSpPr>
            <p:spPr>
              <a:xfrm>
                <a:off x="8574087" y="1215764"/>
                <a:ext cx="1521" cy="5334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Rounded Rectangle 24"/>
              <p:cNvSpPr/>
              <p:nvPr/>
            </p:nvSpPr>
            <p:spPr>
              <a:xfrm>
                <a:off x="7830178" y="1769399"/>
                <a:ext cx="1487815" cy="673272"/>
              </a:xfrm>
              <a:prstGeom prst="round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ad grouping</a:t>
                </a:r>
              </a:p>
            </p:txBody>
          </p:sp>
          <p:sp>
            <p:nvSpPr>
              <p:cNvPr id="26" name="Rounded Rectangle 25"/>
              <p:cNvSpPr/>
              <p:nvPr/>
            </p:nvSpPr>
            <p:spPr>
              <a:xfrm>
                <a:off x="7734126" y="3050968"/>
                <a:ext cx="1679918" cy="850284"/>
              </a:xfrm>
              <a:prstGeom prst="round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alignment</a:t>
                </a:r>
                <a:endParaRPr lang="en-GB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" name="Straight Arrow Connector 26"/>
              <p:cNvCxnSpPr/>
              <p:nvPr/>
            </p:nvCxnSpPr>
            <p:spPr>
              <a:xfrm>
                <a:off x="8574086" y="2488418"/>
                <a:ext cx="1521" cy="5334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>
                <a:off x="9314111" y="3389986"/>
                <a:ext cx="50385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9804787" y="1482174"/>
                <a:ext cx="0" cy="190659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Rounded Rectangle 29"/>
              <p:cNvSpPr/>
              <p:nvPr/>
            </p:nvSpPr>
            <p:spPr>
              <a:xfrm>
                <a:off x="10463279" y="970106"/>
                <a:ext cx="1476696" cy="824114"/>
              </a:xfrm>
              <a:prstGeom prst="round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ariant Calling</a:t>
                </a:r>
              </a:p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GB" sz="1100" b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cf</a:t>
                </a:r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files</a:t>
                </a:r>
              </a:p>
            </p:txBody>
          </p:sp>
          <p:cxnSp>
            <p:nvCxnSpPr>
              <p:cNvPr id="31" name="Straight Arrow Connector 30"/>
              <p:cNvCxnSpPr/>
              <p:nvPr/>
            </p:nvCxnSpPr>
            <p:spPr>
              <a:xfrm>
                <a:off x="9800033" y="1482144"/>
                <a:ext cx="55424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Arrow Connector 31"/>
              <p:cNvCxnSpPr/>
              <p:nvPr/>
            </p:nvCxnSpPr>
            <p:spPr>
              <a:xfrm>
                <a:off x="11198032" y="1859205"/>
                <a:ext cx="1521" cy="586773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Rounded Rectangle 32"/>
              <p:cNvSpPr/>
              <p:nvPr/>
            </p:nvSpPr>
            <p:spPr>
              <a:xfrm>
                <a:off x="10354278" y="3901251"/>
                <a:ext cx="1572052" cy="798285"/>
              </a:xfrm>
              <a:prstGeom prst="round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igh Confidence Variants</a:t>
                </a:r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9808457" y="-196472"/>
                <a:ext cx="2368067" cy="455174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ariant Calling</a:t>
                </a: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6512072" y="504289"/>
                <a:ext cx="1213486" cy="38226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0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icard</a:t>
                </a: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3439873" y="479531"/>
                <a:ext cx="1247835" cy="43570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>
                  <a:lnSpc>
                    <a:spcPct val="150000"/>
                  </a:lnSpc>
                </a:pPr>
                <a:r>
                  <a:rPr lang="en-GB" sz="1100" b="1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Mtools</a:t>
                </a:r>
                <a:endParaRPr lang="en-GB" sz="11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7" name="Picture 16" descr="Image result for gatk best practices pipeline"/>
              <p:cNvPicPr>
                <a:picLocks noChangeAspect="1" noChangeArrowheads="1"/>
              </p:cNvPicPr>
              <p:nvPr/>
            </p:nvPicPr>
            <p:blipFill rotWithShape="1">
              <a:blip r:embed="rId4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11631679" y="666224"/>
                <a:ext cx="911723" cy="48619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8" name="Rectangle 37"/>
              <p:cNvSpPr/>
              <p:nvPr/>
            </p:nvSpPr>
            <p:spPr>
              <a:xfrm>
                <a:off x="10261841" y="446436"/>
                <a:ext cx="1890688" cy="31800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aplotypeCaller</a:t>
                </a:r>
                <a:endParaRPr lang="en-GB" sz="11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04E17B60-AB81-1A4B-92A5-16A43C095CE3}"/>
                </a:ext>
              </a:extLst>
            </p:cNvPr>
            <p:cNvCxnSpPr>
              <a:cxnSpLocks/>
              <a:stCxn id="33" idx="3"/>
              <a:endCxn id="91" idx="1"/>
            </p:cNvCxnSpPr>
            <p:nvPr/>
          </p:nvCxnSpPr>
          <p:spPr>
            <a:xfrm flipV="1">
              <a:off x="9105055" y="3462773"/>
              <a:ext cx="1734116" cy="1436972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17E5DD19-C28C-6345-9995-0034C5A5B919}"/>
                </a:ext>
              </a:extLst>
            </p:cNvPr>
            <p:cNvCxnSpPr>
              <a:cxnSpLocks/>
              <a:stCxn id="33" idx="3"/>
              <a:endCxn id="70" idx="1"/>
            </p:cNvCxnSpPr>
            <p:nvPr/>
          </p:nvCxnSpPr>
          <p:spPr>
            <a:xfrm flipV="1">
              <a:off x="9105055" y="2700746"/>
              <a:ext cx="1727456" cy="2198999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36659FAA-EAFC-1C4B-AF4B-7432EDE21B25}"/>
                </a:ext>
              </a:extLst>
            </p:cNvPr>
            <p:cNvCxnSpPr>
              <a:cxnSpLocks/>
              <a:stCxn id="33" idx="3"/>
              <a:endCxn id="68" idx="1"/>
            </p:cNvCxnSpPr>
            <p:nvPr/>
          </p:nvCxnSpPr>
          <p:spPr>
            <a:xfrm flipV="1">
              <a:off x="9105055" y="1948715"/>
              <a:ext cx="1734116" cy="2951031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F789364D-F1C2-8C4F-9B98-049FFFAE4A83}"/>
                </a:ext>
              </a:extLst>
            </p:cNvPr>
            <p:cNvCxnSpPr>
              <a:cxnSpLocks/>
              <a:stCxn id="33" idx="3"/>
              <a:endCxn id="66" idx="1"/>
            </p:cNvCxnSpPr>
            <p:nvPr/>
          </p:nvCxnSpPr>
          <p:spPr>
            <a:xfrm flipV="1">
              <a:off x="9105055" y="1269636"/>
              <a:ext cx="1734116" cy="3630109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Rounded Rectangle 65">
              <a:extLst>
                <a:ext uri="{FF2B5EF4-FFF2-40B4-BE49-F238E27FC236}">
                  <a16:creationId xmlns:a16="http://schemas.microsoft.com/office/drawing/2014/main" id="{E01C7671-3143-8D4B-8E94-98BC98301A67}"/>
                </a:ext>
              </a:extLst>
            </p:cNvPr>
            <p:cNvSpPr/>
            <p:nvPr/>
          </p:nvSpPr>
          <p:spPr>
            <a:xfrm>
              <a:off x="10839170" y="1103503"/>
              <a:ext cx="1289959" cy="332266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A</a:t>
              </a:r>
            </a:p>
          </p:txBody>
        </p:sp>
        <p:sp>
          <p:nvSpPr>
            <p:cNvPr id="68" name="Rounded Rectangle 67">
              <a:extLst>
                <a:ext uri="{FF2B5EF4-FFF2-40B4-BE49-F238E27FC236}">
                  <a16:creationId xmlns:a16="http://schemas.microsoft.com/office/drawing/2014/main" id="{8EB10A97-3C08-3C40-ADFB-E9F920795526}"/>
                </a:ext>
              </a:extLst>
            </p:cNvPr>
            <p:cNvSpPr/>
            <p:nvPr/>
          </p:nvSpPr>
          <p:spPr>
            <a:xfrm>
              <a:off x="10839170" y="1782580"/>
              <a:ext cx="1289959" cy="332267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MIXTURE</a:t>
              </a:r>
            </a:p>
          </p:txBody>
        </p:sp>
        <p:sp>
          <p:nvSpPr>
            <p:cNvPr id="70" name="Rounded Rectangle 69">
              <a:extLst>
                <a:ext uri="{FF2B5EF4-FFF2-40B4-BE49-F238E27FC236}">
                  <a16:creationId xmlns:a16="http://schemas.microsoft.com/office/drawing/2014/main" id="{D4E55F82-A471-0E41-81C8-E2811EF1D1CA}"/>
                </a:ext>
              </a:extLst>
            </p:cNvPr>
            <p:cNvSpPr/>
            <p:nvPr/>
          </p:nvSpPr>
          <p:spPr>
            <a:xfrm>
              <a:off x="10832510" y="2456261"/>
              <a:ext cx="1300613" cy="488969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ighbour Joining tree</a:t>
              </a: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F818625B-BEC0-7F4B-BE9F-1717F6FCEFB6}"/>
                </a:ext>
              </a:extLst>
            </p:cNvPr>
            <p:cNvSpPr/>
            <p:nvPr/>
          </p:nvSpPr>
          <p:spPr>
            <a:xfrm rot="18458348">
              <a:off x="9907290" y="2871388"/>
              <a:ext cx="1042187" cy="36436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CF2Dis</a:t>
              </a: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E84861A5-CDBC-5443-BF36-F89306231B7F}"/>
                </a:ext>
              </a:extLst>
            </p:cNvPr>
            <p:cNvSpPr/>
            <p:nvPr/>
          </p:nvSpPr>
          <p:spPr>
            <a:xfrm rot="17719521">
              <a:off x="9896736" y="1681999"/>
              <a:ext cx="1124954" cy="28537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 err="1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artPCA</a:t>
              </a:r>
              <a:endParaRPr lang="en-GB" sz="105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9F3A8391-CA3B-0640-8F9F-4EE0DCCE8760}"/>
                </a:ext>
              </a:extLst>
            </p:cNvPr>
            <p:cNvSpPr/>
            <p:nvPr/>
          </p:nvSpPr>
          <p:spPr>
            <a:xfrm rot="18010986">
              <a:off x="9856250" y="2265809"/>
              <a:ext cx="1203036" cy="26458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MIXTURE</a:t>
              </a:r>
            </a:p>
          </p:txBody>
        </p: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3BAF57D1-295A-F047-8D22-48E140415882}"/>
                </a:ext>
              </a:extLst>
            </p:cNvPr>
            <p:cNvCxnSpPr>
              <a:cxnSpLocks/>
              <a:stCxn id="33" idx="3"/>
              <a:endCxn id="92" idx="1"/>
            </p:cNvCxnSpPr>
            <p:nvPr/>
          </p:nvCxnSpPr>
          <p:spPr>
            <a:xfrm flipV="1">
              <a:off x="9105055" y="4177566"/>
              <a:ext cx="1717748" cy="72218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Rounded Rectangle 90">
              <a:extLst>
                <a:ext uri="{FF2B5EF4-FFF2-40B4-BE49-F238E27FC236}">
                  <a16:creationId xmlns:a16="http://schemas.microsoft.com/office/drawing/2014/main" id="{63943A52-C032-9647-B7E4-9F5CFE2F6577}"/>
                </a:ext>
              </a:extLst>
            </p:cNvPr>
            <p:cNvSpPr/>
            <p:nvPr/>
          </p:nvSpPr>
          <p:spPr>
            <a:xfrm>
              <a:off x="10839170" y="3296639"/>
              <a:ext cx="1289959" cy="332268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D decay</a:t>
              </a:r>
            </a:p>
          </p:txBody>
        </p:sp>
        <p:sp>
          <p:nvSpPr>
            <p:cNvPr id="92" name="Rounded Rectangle 91">
              <a:extLst>
                <a:ext uri="{FF2B5EF4-FFF2-40B4-BE49-F238E27FC236}">
                  <a16:creationId xmlns:a16="http://schemas.microsoft.com/office/drawing/2014/main" id="{4E19B9DD-A8FA-AC43-A3F5-D49E0F1A05FD}"/>
                </a:ext>
              </a:extLst>
            </p:cNvPr>
            <p:cNvSpPr/>
            <p:nvPr/>
          </p:nvSpPr>
          <p:spPr>
            <a:xfrm>
              <a:off x="10822802" y="3845780"/>
              <a:ext cx="1381346" cy="663570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pulation differentiation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CAC43B1D-0CD4-4D41-8669-58FF19F8F2D3}"/>
                </a:ext>
              </a:extLst>
            </p:cNvPr>
            <p:cNvSpPr/>
            <p:nvPr/>
          </p:nvSpPr>
          <p:spPr>
            <a:xfrm>
              <a:off x="9190573" y="501431"/>
              <a:ext cx="2938556" cy="445199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pulation Analyses</a:t>
              </a:r>
            </a:p>
          </p:txBody>
        </p:sp>
        <p:sp>
          <p:nvSpPr>
            <p:cNvPr id="95" name="Rounded Rectangle 94">
              <a:extLst>
                <a:ext uri="{FF2B5EF4-FFF2-40B4-BE49-F238E27FC236}">
                  <a16:creationId xmlns:a16="http://schemas.microsoft.com/office/drawing/2014/main" id="{E663E159-7358-A74D-8F1E-38494074DEBF}"/>
                </a:ext>
              </a:extLst>
            </p:cNvPr>
            <p:cNvSpPr/>
            <p:nvPr/>
          </p:nvSpPr>
          <p:spPr>
            <a:xfrm>
              <a:off x="10839169" y="4805661"/>
              <a:ext cx="1300613" cy="473305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leotide diversity</a:t>
              </a:r>
            </a:p>
          </p:txBody>
        </p:sp>
        <p:sp>
          <p:nvSpPr>
            <p:cNvPr id="96" name="Rounded Rectangle 95">
              <a:extLst>
                <a:ext uri="{FF2B5EF4-FFF2-40B4-BE49-F238E27FC236}">
                  <a16:creationId xmlns:a16="http://schemas.microsoft.com/office/drawing/2014/main" id="{F98B32E6-929F-1E46-B36C-1D08351FCB41}"/>
                </a:ext>
              </a:extLst>
            </p:cNvPr>
            <p:cNvSpPr/>
            <p:nvPr/>
          </p:nvSpPr>
          <p:spPr>
            <a:xfrm>
              <a:off x="10829473" y="5621143"/>
              <a:ext cx="1300613" cy="477048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lective sweeps</a:t>
              </a:r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C7B105C0-EDEC-0946-B274-4E3222608E20}"/>
                </a:ext>
              </a:extLst>
            </p:cNvPr>
            <p:cNvSpPr/>
            <p:nvPr/>
          </p:nvSpPr>
          <p:spPr>
            <a:xfrm rot="19234697">
              <a:off x="9599832" y="3627747"/>
              <a:ext cx="1421569" cy="26788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 err="1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pLDdecay</a:t>
              </a:r>
              <a:endParaRPr lang="en-GB" sz="105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" name="Straight Arrow Connector 110">
              <a:extLst>
                <a:ext uri="{FF2B5EF4-FFF2-40B4-BE49-F238E27FC236}">
                  <a16:creationId xmlns:a16="http://schemas.microsoft.com/office/drawing/2014/main" id="{AF71B4E2-3FA8-614C-BF6E-3AC678444A52}"/>
                </a:ext>
              </a:extLst>
            </p:cNvPr>
            <p:cNvCxnSpPr>
              <a:cxnSpLocks/>
              <a:stCxn id="33" idx="3"/>
              <a:endCxn id="95" idx="1"/>
            </p:cNvCxnSpPr>
            <p:nvPr/>
          </p:nvCxnSpPr>
          <p:spPr>
            <a:xfrm>
              <a:off x="9105055" y="4899746"/>
              <a:ext cx="1734114" cy="142567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Arrow Connector 112">
              <a:extLst>
                <a:ext uri="{FF2B5EF4-FFF2-40B4-BE49-F238E27FC236}">
                  <a16:creationId xmlns:a16="http://schemas.microsoft.com/office/drawing/2014/main" id="{51044A0F-CE41-E941-8757-115EE9E31D17}"/>
                </a:ext>
              </a:extLst>
            </p:cNvPr>
            <p:cNvCxnSpPr>
              <a:cxnSpLocks/>
              <a:stCxn id="33" idx="3"/>
              <a:endCxn id="96" idx="1"/>
            </p:cNvCxnSpPr>
            <p:nvPr/>
          </p:nvCxnSpPr>
          <p:spPr>
            <a:xfrm>
              <a:off x="9105055" y="4899746"/>
              <a:ext cx="1724418" cy="959921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C7B105C0-EDEC-0946-B274-4E3222608E20}"/>
                </a:ext>
              </a:extLst>
            </p:cNvPr>
            <p:cNvSpPr/>
            <p:nvPr/>
          </p:nvSpPr>
          <p:spPr>
            <a:xfrm rot="307710">
              <a:off x="9944097" y="4783028"/>
              <a:ext cx="955497" cy="2587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 err="1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CFtools</a:t>
              </a:r>
              <a:endParaRPr lang="en-GB" sz="105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C7B105C0-EDEC-0946-B274-4E3222608E20}"/>
                </a:ext>
              </a:extLst>
            </p:cNvPr>
            <p:cNvSpPr/>
            <p:nvPr/>
          </p:nvSpPr>
          <p:spPr>
            <a:xfrm rot="1733015">
              <a:off x="9994923" y="5456588"/>
              <a:ext cx="954205" cy="1841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P-CLR</a:t>
              </a:r>
            </a:p>
          </p:txBody>
        </p:sp>
        <p:sp>
          <p:nvSpPr>
            <p:cNvPr id="93" name="Rounded Rectangle 92"/>
            <p:cNvSpPr/>
            <p:nvPr/>
          </p:nvSpPr>
          <p:spPr>
            <a:xfrm>
              <a:off x="7902285" y="3150802"/>
              <a:ext cx="1220302" cy="658517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ariant filtration</a:t>
              </a: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C7B105C0-EDEC-0946-B274-4E3222608E20}"/>
                </a:ext>
              </a:extLst>
            </p:cNvPr>
            <p:cNvSpPr/>
            <p:nvPr/>
          </p:nvSpPr>
          <p:spPr>
            <a:xfrm rot="20254811">
              <a:off x="9944857" y="4106193"/>
              <a:ext cx="955497" cy="2587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dirty="0" err="1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CFtools</a:t>
              </a:r>
              <a:endParaRPr lang="en-GB" sz="105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277591" y="3826516"/>
              <a:ext cx="1341703" cy="9091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Q&lt;40, QD&lt;2, </a:t>
              </a:r>
            </a:p>
            <a:p>
              <a:pPr algn="ctr"/>
              <a:r>
                <a:rPr lang="en-GB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FS&gt;60 and 2&lt;DP&lt;50</a:t>
              </a:r>
            </a:p>
            <a:p>
              <a:pPr algn="ctr"/>
              <a:endParaRPr lang="en-GB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Straight Arrow Connector 81"/>
            <p:cNvCxnSpPr/>
            <p:nvPr/>
          </p:nvCxnSpPr>
          <p:spPr>
            <a:xfrm>
              <a:off x="8504894" y="3873815"/>
              <a:ext cx="1253" cy="573914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0" y="19891"/>
            <a:ext cx="768159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Fig. S13</a:t>
            </a:r>
          </a:p>
        </p:txBody>
      </p:sp>
    </p:spTree>
    <p:extLst>
      <p:ext uri="{BB962C8B-B14F-4D97-AF65-F5344CB8AC3E}">
        <p14:creationId xmlns:p14="http://schemas.microsoft.com/office/powerpoint/2010/main" val="26021713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34">
            <a:extLst>
              <a:ext uri="{FF2B5EF4-FFF2-40B4-BE49-F238E27FC236}">
                <a16:creationId xmlns:a16="http://schemas.microsoft.com/office/drawing/2014/main" id="{42C215D9-AC9E-F9B5-64B2-2152BFD3B755}"/>
              </a:ext>
            </a:extLst>
          </p:cNvPr>
          <p:cNvSpPr txBox="1"/>
          <p:nvPr/>
        </p:nvSpPr>
        <p:spPr>
          <a:xfrm>
            <a:off x="0" y="95699"/>
            <a:ext cx="67358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Fig. S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D0A70BA-8B39-D053-5373-56C104833D4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667" t="12057" r="20372" b="4050"/>
          <a:stretch>
            <a:fillRect/>
          </a:stretch>
        </p:blipFill>
        <p:spPr>
          <a:xfrm>
            <a:off x="66468" y="967245"/>
            <a:ext cx="8029643" cy="4923510"/>
          </a:xfrm>
          <a:prstGeom prst="rect">
            <a:avLst/>
          </a:prstGeom>
        </p:spPr>
      </p:pic>
      <p:grpSp>
        <p:nvGrpSpPr>
          <p:cNvPr id="18" name="Group 17">
            <a:extLst>
              <a:ext uri="{FF2B5EF4-FFF2-40B4-BE49-F238E27FC236}">
                <a16:creationId xmlns:a16="http://schemas.microsoft.com/office/drawing/2014/main" id="{DE8D1EFA-8147-CF60-E9EB-1471831C0182}"/>
              </a:ext>
            </a:extLst>
          </p:cNvPr>
          <p:cNvGrpSpPr/>
          <p:nvPr/>
        </p:nvGrpSpPr>
        <p:grpSpPr>
          <a:xfrm>
            <a:off x="8046233" y="4239752"/>
            <a:ext cx="1671147" cy="912636"/>
            <a:chOff x="8008758" y="4239752"/>
            <a:chExt cx="1671147" cy="912636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1970616-226D-3D96-F112-638F8732CBF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79171" t="46764" r="3921" b="50323"/>
            <a:stretch>
              <a:fillRect/>
            </a:stretch>
          </p:blipFill>
          <p:spPr>
            <a:xfrm>
              <a:off x="8008758" y="4844004"/>
              <a:ext cx="1671145" cy="161958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360A9D0-B240-31E3-4045-14F8689699D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79171" t="44028" r="3921" b="53059"/>
            <a:stretch>
              <a:fillRect/>
            </a:stretch>
          </p:blipFill>
          <p:spPr>
            <a:xfrm>
              <a:off x="8008758" y="4990431"/>
              <a:ext cx="1671145" cy="161957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DC9C3007-3001-D5B8-0247-C733CF7541B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79171" t="54814" r="3921" b="42879"/>
            <a:stretch>
              <a:fillRect/>
            </a:stretch>
          </p:blipFill>
          <p:spPr>
            <a:xfrm>
              <a:off x="8008760" y="4239752"/>
              <a:ext cx="1671145" cy="128239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71FE1012-5410-6FE8-26A4-D1F6D0671F4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79171" t="51918" r="3921" b="44973"/>
            <a:stretch>
              <a:fillRect/>
            </a:stretch>
          </p:blipFill>
          <p:spPr>
            <a:xfrm>
              <a:off x="8008760" y="4379600"/>
              <a:ext cx="1671145" cy="172845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DA5ED119-FD31-2290-CAC0-1E4E583AE0B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79171" t="49644" r="3921" b="48049"/>
            <a:stretch>
              <a:fillRect/>
            </a:stretch>
          </p:blipFill>
          <p:spPr>
            <a:xfrm>
              <a:off x="8008760" y="4552445"/>
              <a:ext cx="1671145" cy="128239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71CFB3C5-877C-BD62-04B7-857ECBEAE0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79171" t="40992" r="3921" b="55899"/>
            <a:stretch>
              <a:fillRect/>
            </a:stretch>
          </p:blipFill>
          <p:spPr>
            <a:xfrm>
              <a:off x="8008759" y="4667984"/>
              <a:ext cx="1671145" cy="17284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0556568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6B54FCB1-1767-4AE8-6C57-FE620A02B9D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437" t="5691" r="17053" b="57073"/>
          <a:stretch/>
        </p:blipFill>
        <p:spPr>
          <a:xfrm>
            <a:off x="395281" y="1403706"/>
            <a:ext cx="7599759" cy="4811357"/>
          </a:xfrm>
          <a:prstGeom prst="rect">
            <a:avLst/>
          </a:prstGeom>
        </p:spPr>
      </p:pic>
      <p:sp>
        <p:nvSpPr>
          <p:cNvPr id="3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-32657" y="67124"/>
            <a:ext cx="67358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Fig. S3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7995040" y="3809384"/>
            <a:ext cx="2105054" cy="1015663"/>
            <a:chOff x="10496119" y="4741008"/>
            <a:chExt cx="2590836" cy="125004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B54FCB1-1767-4AE8-6C57-FE620A02B9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2906" t="20537" r="14520" b="73264"/>
            <a:stretch/>
          </p:blipFill>
          <p:spPr>
            <a:xfrm>
              <a:off x="10496119" y="4828725"/>
              <a:ext cx="348028" cy="1104614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8CA8C4E-6049-3253-37C2-727E287A03B8}"/>
                </a:ext>
              </a:extLst>
            </p:cNvPr>
            <p:cNvSpPr txBox="1"/>
            <p:nvPr/>
          </p:nvSpPr>
          <p:spPr>
            <a:xfrm>
              <a:off x="10764968" y="4741008"/>
              <a:ext cx="2321987" cy="12500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CC8D04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Fodder beet</a:t>
              </a:r>
            </a:p>
            <a:p>
              <a:r>
                <a:rPr lang="en-US" sz="1200" dirty="0">
                  <a:solidFill>
                    <a:srgbClr val="AD0209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Table beet</a:t>
              </a:r>
            </a:p>
            <a:p>
              <a:r>
                <a:rPr lang="en-US" sz="1200" dirty="0">
                  <a:solidFill>
                    <a:srgbClr val="7FB83E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Leaf beet GP1</a:t>
              </a:r>
              <a:endParaRPr lang="en-US" sz="1200" dirty="0">
                <a:solidFill>
                  <a:srgbClr val="0075DD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  <a:p>
              <a:r>
                <a:rPr lang="en-US" sz="1200" dirty="0">
                  <a:solidFill>
                    <a:srgbClr val="4CA1BF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Leaf beet GP2</a:t>
              </a:r>
            </a:p>
            <a:p>
              <a:r>
                <a:rPr lang="en-US" sz="1200" dirty="0">
                  <a:solidFill>
                    <a:srgbClr val="04541A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Sugar beet</a:t>
              </a:r>
              <a:endParaRPr lang="en-US" sz="1200" dirty="0">
                <a:solidFill>
                  <a:srgbClr val="072AD9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763339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7423260-3EE3-8ED0-E16B-41C8BBAD11F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361" r="4522" b="52820"/>
          <a:stretch/>
        </p:blipFill>
        <p:spPr>
          <a:xfrm>
            <a:off x="1688153" y="642938"/>
            <a:ext cx="6263640" cy="5572125"/>
          </a:xfrm>
          <a:prstGeom prst="rect">
            <a:avLst/>
          </a:prstGeom>
        </p:spPr>
      </p:pic>
      <p:sp>
        <p:nvSpPr>
          <p:cNvPr id="3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81643" y="75288"/>
            <a:ext cx="67358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Fig. S4</a:t>
            </a:r>
          </a:p>
        </p:txBody>
      </p:sp>
    </p:spTree>
    <p:extLst>
      <p:ext uri="{BB962C8B-B14F-4D97-AF65-F5344CB8AC3E}">
        <p14:creationId xmlns:p14="http://schemas.microsoft.com/office/powerpoint/2010/main" val="32384158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-28575" y="87046"/>
            <a:ext cx="10040731" cy="6115901"/>
            <a:chOff x="-28575" y="87046"/>
            <a:chExt cx="10040731" cy="6115901"/>
          </a:xfrm>
        </p:grpSpPr>
        <p:sp>
          <p:nvSpPr>
            <p:cNvPr id="17" name="Textfeld 34">
              <a:extLst>
                <a:ext uri="{FF2B5EF4-FFF2-40B4-BE49-F238E27FC236}">
                  <a16:creationId xmlns:a16="http://schemas.microsoft.com/office/drawing/2014/main" id="{41E97575-BAB2-3D65-1E10-0331810EF907}"/>
                </a:ext>
              </a:extLst>
            </p:cNvPr>
            <p:cNvSpPr txBox="1"/>
            <p:nvPr/>
          </p:nvSpPr>
          <p:spPr>
            <a:xfrm>
              <a:off x="-28575" y="87046"/>
              <a:ext cx="67358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63" dirty="0"/>
                <a:t>Fig. S5</a:t>
              </a:r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239532" y="1553675"/>
              <a:ext cx="9426934" cy="2130936"/>
              <a:chOff x="294809" y="1120908"/>
              <a:chExt cx="11602380" cy="2622690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294809" y="1120908"/>
                <a:ext cx="11602380" cy="2622690"/>
                <a:chOff x="294809" y="1120908"/>
                <a:chExt cx="11602380" cy="2622690"/>
              </a:xfrm>
            </p:grpSpPr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B0E977B1-EC81-97C5-91CD-71A7F5997C80}"/>
                    </a:ext>
                  </a:extLst>
                </p:cNvPr>
                <p:cNvGrpSpPr/>
                <p:nvPr/>
              </p:nvGrpSpPr>
              <p:grpSpPr>
                <a:xfrm>
                  <a:off x="294809" y="1333500"/>
                  <a:ext cx="11602380" cy="2410098"/>
                  <a:chOff x="152400" y="362301"/>
                  <a:chExt cx="10730238" cy="1917260"/>
                </a:xfrm>
              </p:grpSpPr>
              <p:pic>
                <p:nvPicPr>
                  <p:cNvPr id="3" name="Picture 2">
                    <a:extLst>
                      <a:ext uri="{FF2B5EF4-FFF2-40B4-BE49-F238E27FC236}">
                        <a16:creationId xmlns:a16="http://schemas.microsoft.com/office/drawing/2014/main" id="{0FF6CEFD-B41E-C2AE-05DE-13F3B76978F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17699" t="5319" r="60219" b="67874"/>
                  <a:stretch/>
                </p:blipFill>
                <p:spPr>
                  <a:xfrm>
                    <a:off x="152400" y="377455"/>
                    <a:ext cx="2217313" cy="1902106"/>
                  </a:xfrm>
                  <a:prstGeom prst="rect">
                    <a:avLst/>
                  </a:prstGeom>
                </p:spPr>
              </p:pic>
              <p:pic>
                <p:nvPicPr>
                  <p:cNvPr id="4" name="Picture 3">
                    <a:extLst>
                      <a:ext uri="{FF2B5EF4-FFF2-40B4-BE49-F238E27FC236}">
                        <a16:creationId xmlns:a16="http://schemas.microsoft.com/office/drawing/2014/main" id="{840F2E03-FBCD-AC73-054D-13FEBF3305D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17699" t="38534" r="60219" b="34871"/>
                  <a:stretch/>
                </p:blipFill>
                <p:spPr>
                  <a:xfrm>
                    <a:off x="6466805" y="392610"/>
                    <a:ext cx="2217313" cy="1886951"/>
                  </a:xfrm>
                  <a:prstGeom prst="rect">
                    <a:avLst/>
                  </a:prstGeom>
                </p:spPr>
              </p:pic>
              <p:pic>
                <p:nvPicPr>
                  <p:cNvPr id="10" name="Picture 9">
                    <a:extLst>
                      <a:ext uri="{FF2B5EF4-FFF2-40B4-BE49-F238E27FC236}">
                        <a16:creationId xmlns:a16="http://schemas.microsoft.com/office/drawing/2014/main" id="{695992AA-5C2A-2C27-AA64-6BE7AFE48DF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40017" t="5106" r="37901" b="67873"/>
                  <a:stretch/>
                </p:blipFill>
                <p:spPr>
                  <a:xfrm>
                    <a:off x="2210342" y="362301"/>
                    <a:ext cx="2217314" cy="1917260"/>
                  </a:xfrm>
                  <a:prstGeom prst="rect">
                    <a:avLst/>
                  </a:prstGeom>
                </p:spPr>
              </p:pic>
              <p:pic>
                <p:nvPicPr>
                  <p:cNvPr id="11" name="Picture 10">
                    <a:extLst>
                      <a:ext uri="{FF2B5EF4-FFF2-40B4-BE49-F238E27FC236}">
                        <a16:creationId xmlns:a16="http://schemas.microsoft.com/office/drawing/2014/main" id="{A4478B26-8EE2-01C5-B56E-F003914DC70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62559" t="5533" r="14173" b="67873"/>
                  <a:stretch/>
                </p:blipFill>
                <p:spPr>
                  <a:xfrm>
                    <a:off x="4289734" y="392610"/>
                    <a:ext cx="2336441" cy="1886951"/>
                  </a:xfrm>
                  <a:prstGeom prst="rect">
                    <a:avLst/>
                  </a:prstGeom>
                </p:spPr>
              </p:pic>
              <p:pic>
                <p:nvPicPr>
                  <p:cNvPr id="12" name="Picture 11">
                    <a:extLst>
                      <a:ext uri="{FF2B5EF4-FFF2-40B4-BE49-F238E27FC236}">
                        <a16:creationId xmlns:a16="http://schemas.microsoft.com/office/drawing/2014/main" id="{1A23E46A-71E0-8266-FAE9-C0BB9C41615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40241" t="38274" r="36490" b="34917"/>
                  <a:stretch/>
                </p:blipFill>
                <p:spPr>
                  <a:xfrm>
                    <a:off x="8546196" y="377455"/>
                    <a:ext cx="2336442" cy="1902106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9" name="TextBox 18"/>
                <p:cNvSpPr txBox="1"/>
                <p:nvPr/>
              </p:nvSpPr>
              <p:spPr>
                <a:xfrm>
                  <a:off x="3002590" y="112090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2</a:t>
                  </a: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691218" y="1120910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1</a:t>
                  </a: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5313962" y="112090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3</a:t>
                  </a: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7533581" y="1120908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4</a:t>
                  </a: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9794182" y="1120908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5</a:t>
                  </a:r>
                </a:p>
              </p:txBody>
            </p:sp>
          </p:grpSp>
          <p:sp>
            <p:nvSpPr>
              <p:cNvPr id="35" name="Rectangle 34"/>
              <p:cNvSpPr/>
              <p:nvPr/>
            </p:nvSpPr>
            <p:spPr>
              <a:xfrm>
                <a:off x="1485900" y="1386180"/>
                <a:ext cx="11430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3931723" y="1386180"/>
                <a:ext cx="911604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6133772" y="1405230"/>
                <a:ext cx="1005414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8491864" y="1382572"/>
                <a:ext cx="911604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10736195" y="1376887"/>
                <a:ext cx="989597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7903260" y="4163630"/>
              <a:ext cx="2108896" cy="1223412"/>
              <a:chOff x="10188411" y="5282175"/>
              <a:chExt cx="2595564" cy="1505738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F8CA8C4E-6049-3253-37C2-727E287A03B8}"/>
                  </a:ext>
                </a:extLst>
              </p:cNvPr>
              <p:cNvSpPr txBox="1"/>
              <p:nvPr/>
            </p:nvSpPr>
            <p:spPr>
              <a:xfrm>
                <a:off x="10461988" y="5282175"/>
                <a:ext cx="2321987" cy="1505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solidFill>
                      <a:srgbClr val="AD0209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Table beet</a:t>
                </a:r>
              </a:p>
              <a:p>
                <a:r>
                  <a:rPr lang="en-US" sz="1050" dirty="0">
                    <a:solidFill>
                      <a:srgbClr val="04541A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Sugar beet</a:t>
                </a:r>
                <a:endParaRPr lang="en-US" sz="1050" dirty="0">
                  <a:solidFill>
                    <a:srgbClr val="4A0058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  <a:p>
                <a:r>
                  <a:rPr lang="en-US" sz="1050" dirty="0">
                    <a:solidFill>
                      <a:srgbClr val="072AD9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Mediterranean sea beet</a:t>
                </a:r>
              </a:p>
              <a:p>
                <a:r>
                  <a:rPr lang="en-US" sz="1050" dirty="0">
                    <a:solidFill>
                      <a:srgbClr val="4A0058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Atlantic sea beet</a:t>
                </a:r>
              </a:p>
              <a:p>
                <a:r>
                  <a:rPr lang="en-US" sz="1050" dirty="0">
                    <a:solidFill>
                      <a:srgbClr val="7FB83E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Leaf beet</a:t>
                </a:r>
                <a:endParaRPr lang="en-US" sz="1050" dirty="0">
                  <a:solidFill>
                    <a:srgbClr val="0075DD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  <a:p>
                <a:r>
                  <a:rPr lang="en-US" sz="1050" dirty="0">
                    <a:solidFill>
                      <a:srgbClr val="CC8D04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Fodder beet</a:t>
                </a:r>
              </a:p>
              <a:p>
                <a:r>
                  <a:rPr lang="en-US" sz="1050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Diversity panel 245 samples</a:t>
                </a: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10192747" y="5426685"/>
                <a:ext cx="253430" cy="0"/>
              </a:xfrm>
              <a:prstGeom prst="line">
                <a:avLst/>
              </a:prstGeom>
              <a:ln w="19050">
                <a:solidFill>
                  <a:srgbClr val="AD030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10188411" y="5646328"/>
                <a:ext cx="253430" cy="0"/>
              </a:xfrm>
              <a:prstGeom prst="line">
                <a:avLst/>
              </a:prstGeom>
              <a:ln w="19050">
                <a:solidFill>
                  <a:srgbClr val="03541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10188411" y="5843952"/>
                <a:ext cx="253430" cy="0"/>
              </a:xfrm>
              <a:prstGeom prst="line">
                <a:avLst/>
              </a:prstGeom>
              <a:ln w="19050">
                <a:solidFill>
                  <a:srgbClr val="072AD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>
                <a:off x="10208164" y="6014367"/>
                <a:ext cx="253430" cy="0"/>
              </a:xfrm>
              <a:prstGeom prst="line">
                <a:avLst/>
              </a:prstGeom>
              <a:ln w="19050">
                <a:solidFill>
                  <a:srgbClr val="552F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/>
              <p:cNvCxnSpPr/>
              <p:nvPr/>
            </p:nvCxnSpPr>
            <p:spPr>
              <a:xfrm>
                <a:off x="10208164" y="6249499"/>
                <a:ext cx="253430" cy="0"/>
              </a:xfrm>
              <a:prstGeom prst="line">
                <a:avLst/>
              </a:prstGeom>
              <a:ln w="19050">
                <a:solidFill>
                  <a:srgbClr val="7FB83E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/>
              <p:cNvCxnSpPr/>
              <p:nvPr/>
            </p:nvCxnSpPr>
            <p:spPr>
              <a:xfrm>
                <a:off x="10208164" y="6448791"/>
                <a:ext cx="253430" cy="0"/>
              </a:xfrm>
              <a:prstGeom prst="line">
                <a:avLst/>
              </a:prstGeom>
              <a:ln w="19050">
                <a:solidFill>
                  <a:srgbClr val="CC8D0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>
                <a:off x="10208164" y="6641123"/>
                <a:ext cx="253430" cy="0"/>
              </a:xfrm>
              <a:prstGeom prst="line">
                <a:avLst/>
              </a:prstGeom>
              <a:ln w="1905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 22"/>
            <p:cNvGrpSpPr/>
            <p:nvPr/>
          </p:nvGrpSpPr>
          <p:grpSpPr>
            <a:xfrm>
              <a:off x="239533" y="3963576"/>
              <a:ext cx="7648200" cy="2181255"/>
              <a:chOff x="1201823" y="4173379"/>
              <a:chExt cx="9413169" cy="2684621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1201823" y="4173379"/>
                <a:ext cx="9413169" cy="2684621"/>
                <a:chOff x="1201823" y="4173379"/>
                <a:chExt cx="9413169" cy="2684621"/>
              </a:xfrm>
            </p:grpSpPr>
            <p:grpSp>
              <p:nvGrpSpPr>
                <p:cNvPr id="16" name="Group 15">
                  <a:extLst>
                    <a:ext uri="{FF2B5EF4-FFF2-40B4-BE49-F238E27FC236}">
                      <a16:creationId xmlns:a16="http://schemas.microsoft.com/office/drawing/2014/main" id="{76006854-8E0C-97F1-56DE-2822AF28C9F2}"/>
                    </a:ext>
                  </a:extLst>
                </p:cNvPr>
                <p:cNvGrpSpPr/>
                <p:nvPr/>
              </p:nvGrpSpPr>
              <p:grpSpPr>
                <a:xfrm>
                  <a:off x="1201823" y="4400550"/>
                  <a:ext cx="9413169" cy="2457450"/>
                  <a:chOff x="0" y="3811293"/>
                  <a:chExt cx="9693978" cy="2338072"/>
                </a:xfrm>
              </p:grpSpPr>
              <p:pic>
                <p:nvPicPr>
                  <p:cNvPr id="5" name="Picture 4">
                    <a:extLst>
                      <a:ext uri="{FF2B5EF4-FFF2-40B4-BE49-F238E27FC236}">
                        <a16:creationId xmlns:a16="http://schemas.microsoft.com/office/drawing/2014/main" id="{6AAE65A4-AFE4-76F0-E5B9-2F732A9A893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17699" t="71086" r="60317" b="1362"/>
                  <a:stretch/>
                </p:blipFill>
                <p:spPr>
                  <a:xfrm>
                    <a:off x="2338292" y="3811293"/>
                    <a:ext cx="2498021" cy="2338072"/>
                  </a:xfrm>
                  <a:prstGeom prst="rect">
                    <a:avLst/>
                  </a:prstGeom>
                </p:spPr>
              </p:pic>
              <p:pic>
                <p:nvPicPr>
                  <p:cNvPr id="6" name="Picture 5">
                    <a:extLst>
                      <a:ext uri="{FF2B5EF4-FFF2-40B4-BE49-F238E27FC236}">
                        <a16:creationId xmlns:a16="http://schemas.microsoft.com/office/drawing/2014/main" id="{A9D3BCD1-A793-B8A5-0D1F-1281ECBDEB9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63122" t="38469" r="14893" b="34191"/>
                  <a:stretch/>
                </p:blipFill>
                <p:spPr>
                  <a:xfrm>
                    <a:off x="0" y="3829418"/>
                    <a:ext cx="2498021" cy="2319947"/>
                  </a:xfrm>
                  <a:prstGeom prst="rect">
                    <a:avLst/>
                  </a:prstGeom>
                </p:spPr>
              </p:pic>
              <p:pic>
                <p:nvPicPr>
                  <p:cNvPr id="14" name="Picture 13">
                    <a:extLst>
                      <a:ext uri="{FF2B5EF4-FFF2-40B4-BE49-F238E27FC236}">
                        <a16:creationId xmlns:a16="http://schemas.microsoft.com/office/drawing/2014/main" id="{BE75674B-67C7-20ED-A7E6-E1AC717CC4C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40408" t="71300" r="37822" b="1362"/>
                  <a:stretch/>
                </p:blipFill>
                <p:spPr>
                  <a:xfrm>
                    <a:off x="4700956" y="3829418"/>
                    <a:ext cx="2473650" cy="2319947"/>
                  </a:xfrm>
                  <a:prstGeom prst="rect">
                    <a:avLst/>
                  </a:prstGeom>
                </p:spPr>
              </p:pic>
              <p:pic>
                <p:nvPicPr>
                  <p:cNvPr id="15" name="Picture 14">
                    <a:extLst>
                      <a:ext uri="{FF2B5EF4-FFF2-40B4-BE49-F238E27FC236}">
                        <a16:creationId xmlns:a16="http://schemas.microsoft.com/office/drawing/2014/main" id="{41044AF4-44CF-5C73-A9B1-B93A6354181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62430" t="71094" r="14207" b="1362"/>
                  <a:stretch/>
                </p:blipFill>
                <p:spPr>
                  <a:xfrm>
                    <a:off x="7039248" y="3811891"/>
                    <a:ext cx="2654730" cy="2337474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30" name="TextBox 29"/>
                <p:cNvSpPr txBox="1"/>
                <p:nvPr/>
              </p:nvSpPr>
              <p:spPr>
                <a:xfrm>
                  <a:off x="1643581" y="417337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6</a:t>
                  </a: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3914139" y="417337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7</a:t>
                  </a: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6206837" y="417337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8</a:t>
                  </a: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8536684" y="4173379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Chromosome 9</a:t>
                  </a:r>
                </a:p>
              </p:txBody>
            </p:sp>
          </p:grpSp>
          <p:sp>
            <p:nvSpPr>
              <p:cNvPr id="40" name="Rectangle 39"/>
              <p:cNvSpPr/>
              <p:nvPr/>
            </p:nvSpPr>
            <p:spPr>
              <a:xfrm>
                <a:off x="2439176" y="4419600"/>
                <a:ext cx="11430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4768421" y="4419600"/>
                <a:ext cx="11430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7086202" y="4395787"/>
                <a:ext cx="11430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9379965" y="4395787"/>
                <a:ext cx="11430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2886164" y="3524011"/>
              <a:ext cx="922894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729272" y="3533685"/>
              <a:ext cx="871258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6559295" y="3530317"/>
              <a:ext cx="680687" cy="20005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700" dirty="0" err="1"/>
                <a:t>Distance</a:t>
              </a:r>
              <a:r>
                <a:rPr lang="de-DE" sz="700" dirty="0"/>
                <a:t> (</a:t>
              </a:r>
              <a:r>
                <a:rPr lang="de-DE" sz="700" dirty="0" err="1"/>
                <a:t>kb</a:t>
              </a:r>
              <a:r>
                <a:rPr lang="de-DE" sz="700" dirty="0"/>
                <a:t>)</a:t>
              </a:r>
              <a:endParaRPr lang="en-GB" sz="7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6565692" y="3546891"/>
              <a:ext cx="825325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017510" y="3540723"/>
              <a:ext cx="88047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8449151" y="3540723"/>
              <a:ext cx="894874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876490" y="5956726"/>
              <a:ext cx="957533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000" dirty="0" err="1"/>
                <a:t>Distance</a:t>
              </a:r>
              <a:r>
                <a:rPr lang="de-DE" sz="1000" dirty="0"/>
                <a:t> (</a:t>
              </a:r>
              <a:r>
                <a:rPr lang="de-DE" sz="1000" dirty="0" err="1"/>
                <a:t>kb</a:t>
              </a:r>
              <a:r>
                <a:rPr lang="de-DE" sz="1000" dirty="0"/>
                <a:t>)</a:t>
              </a:r>
              <a:endParaRPr lang="en-GB" sz="10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865596" y="5960254"/>
              <a:ext cx="845014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754154" y="5956726"/>
              <a:ext cx="944773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642712" y="5956726"/>
              <a:ext cx="87367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59" name="TextBox 58"/>
            <p:cNvSpPr txBox="1"/>
            <p:nvPr/>
          </p:nvSpPr>
          <p:spPr>
            <a:xfrm rot="16200000">
              <a:off x="70705" y="2350042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61" name="TextBox 60"/>
            <p:cNvSpPr txBox="1"/>
            <p:nvPr/>
          </p:nvSpPr>
          <p:spPr>
            <a:xfrm rot="16200000">
              <a:off x="1933445" y="2377028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62" name="TextBox 61"/>
            <p:cNvSpPr txBox="1"/>
            <p:nvPr/>
          </p:nvSpPr>
          <p:spPr>
            <a:xfrm rot="16200000">
              <a:off x="3799256" y="2368672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63" name="TextBox 62"/>
            <p:cNvSpPr txBox="1"/>
            <p:nvPr/>
          </p:nvSpPr>
          <p:spPr>
            <a:xfrm rot="16200000">
              <a:off x="5624506" y="2394540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64" name="TextBox 63"/>
            <p:cNvSpPr txBox="1"/>
            <p:nvPr/>
          </p:nvSpPr>
          <p:spPr>
            <a:xfrm rot="16200000">
              <a:off x="7484715" y="2412226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65" name="TextBox 64"/>
            <p:cNvSpPr txBox="1"/>
            <p:nvPr/>
          </p:nvSpPr>
          <p:spPr>
            <a:xfrm rot="16200000">
              <a:off x="98168" y="4849256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66" name="TextBox 65"/>
            <p:cNvSpPr txBox="1"/>
            <p:nvPr/>
          </p:nvSpPr>
          <p:spPr>
            <a:xfrm rot="16200000">
              <a:off x="1921264" y="4818777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67" name="TextBox 66"/>
            <p:cNvSpPr txBox="1"/>
            <p:nvPr/>
          </p:nvSpPr>
          <p:spPr>
            <a:xfrm rot="16200000">
              <a:off x="3777385" y="4849256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68" name="TextBox 67"/>
            <p:cNvSpPr txBox="1"/>
            <p:nvPr/>
          </p:nvSpPr>
          <p:spPr>
            <a:xfrm rot="16200000">
              <a:off x="5701076" y="4789979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</p:grpSp>
    </p:spTree>
    <p:extLst>
      <p:ext uri="{BB962C8B-B14F-4D97-AF65-F5344CB8AC3E}">
        <p14:creationId xmlns:p14="http://schemas.microsoft.com/office/powerpoint/2010/main" val="35113456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3165" y="71206"/>
            <a:ext cx="9856170" cy="6185215"/>
            <a:chOff x="3165" y="71206"/>
            <a:chExt cx="9856170" cy="6185215"/>
          </a:xfrm>
        </p:grpSpPr>
        <p:sp>
          <p:nvSpPr>
            <p:cNvPr id="12" name="Textfeld 34">
              <a:extLst>
                <a:ext uri="{FF2B5EF4-FFF2-40B4-BE49-F238E27FC236}">
                  <a16:creationId xmlns:a16="http://schemas.microsoft.com/office/drawing/2014/main" id="{41E97575-BAB2-3D65-1E10-0331810EF907}"/>
                </a:ext>
              </a:extLst>
            </p:cNvPr>
            <p:cNvSpPr txBox="1"/>
            <p:nvPr/>
          </p:nvSpPr>
          <p:spPr>
            <a:xfrm>
              <a:off x="48986" y="71206"/>
              <a:ext cx="67358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63" dirty="0"/>
                <a:t>Fig. S6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051081" y="3818745"/>
              <a:ext cx="14859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650" b="1">
                  <a:latin typeface="Senif"/>
                </a:defRPr>
              </a:lvl1pPr>
            </a:lstStyle>
            <a:p>
              <a:r>
                <a:rPr lang="en-US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Atlantic </a:t>
              </a:r>
              <a:r>
                <a:rPr lang="en-GB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sea beet</a:t>
              </a:r>
              <a:endParaRPr lang="en-GB" sz="1000" i="1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86796" y="1428136"/>
              <a:ext cx="9772539" cy="2168794"/>
              <a:chOff x="106826" y="966397"/>
              <a:chExt cx="12027740" cy="2669285"/>
            </a:xfrm>
          </p:grpSpPr>
          <p:grpSp>
            <p:nvGrpSpPr>
              <p:cNvPr id="18" name="Group 17"/>
              <p:cNvGrpSpPr/>
              <p:nvPr/>
            </p:nvGrpSpPr>
            <p:grpSpPr>
              <a:xfrm>
                <a:off x="106826" y="966397"/>
                <a:ext cx="12027740" cy="2669285"/>
                <a:chOff x="106826" y="966397"/>
                <a:chExt cx="12027740" cy="2669285"/>
              </a:xfrm>
            </p:grpSpPr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7DBDFB78-2B73-B82A-053C-9CF88AF8EA4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l="9883" t="37192" r="65226" b="34900"/>
                <a:stretch/>
              </p:blipFill>
              <p:spPr>
                <a:xfrm>
                  <a:off x="9128019" y="1181100"/>
                  <a:ext cx="3006547" cy="2382012"/>
                </a:xfrm>
                <a:prstGeom prst="rect">
                  <a:avLst/>
                </a:prstGeom>
              </p:spPr>
            </p:pic>
            <p:grpSp>
              <p:nvGrpSpPr>
                <p:cNvPr id="14" name="Group 13"/>
                <p:cNvGrpSpPr/>
                <p:nvPr/>
              </p:nvGrpSpPr>
              <p:grpSpPr>
                <a:xfrm>
                  <a:off x="106826" y="974056"/>
                  <a:ext cx="9079251" cy="2661626"/>
                  <a:chOff x="106826" y="974056"/>
                  <a:chExt cx="9079251" cy="2661626"/>
                </a:xfrm>
              </p:grpSpPr>
              <p:grpSp>
                <p:nvGrpSpPr>
                  <p:cNvPr id="2" name="Group 1"/>
                  <p:cNvGrpSpPr/>
                  <p:nvPr/>
                </p:nvGrpSpPr>
                <p:grpSpPr>
                  <a:xfrm>
                    <a:off x="106826" y="1117600"/>
                    <a:ext cx="9079251" cy="2518082"/>
                    <a:chOff x="48768" y="1085423"/>
                    <a:chExt cx="9079251" cy="2518082"/>
                  </a:xfrm>
                </p:grpSpPr>
                <p:pic>
                  <p:nvPicPr>
                    <p:cNvPr id="3" name="Picture 2">
                      <a:extLst>
                        <a:ext uri="{FF2B5EF4-FFF2-40B4-BE49-F238E27FC236}">
                          <a16:creationId xmlns:a16="http://schemas.microsoft.com/office/drawing/2014/main" id="{EA47603F-ACB1-6E41-4F17-2E530F6BF9D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email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9840" t="3255" r="65200" b="67108"/>
                    <a:stretch/>
                  </p:blipFill>
                  <p:spPr>
                    <a:xfrm>
                      <a:off x="48768" y="1098123"/>
                      <a:ext cx="3006547" cy="246498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" name="Picture 3">
                      <a:extLst>
                        <a:ext uri="{FF2B5EF4-FFF2-40B4-BE49-F238E27FC236}">
                          <a16:creationId xmlns:a16="http://schemas.microsoft.com/office/drawing/2014/main" id="{F3304450-EFBC-3729-F36B-6650D568333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email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36791" t="3382" r="38368" b="66947"/>
                    <a:stretch/>
                  </p:blipFill>
                  <p:spPr>
                    <a:xfrm>
                      <a:off x="3055315" y="1085423"/>
                      <a:ext cx="3006547" cy="251808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" name="Picture 4">
                      <a:extLst>
                        <a:ext uri="{FF2B5EF4-FFF2-40B4-BE49-F238E27FC236}">
                          <a16:creationId xmlns:a16="http://schemas.microsoft.com/office/drawing/2014/main" id="{CD72DD61-72FE-0758-2DA6-EC8EA0F29D7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email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63072" t="3484" r="11532" b="66719"/>
                    <a:stretch/>
                  </p:blipFill>
                  <p:spPr>
                    <a:xfrm>
                      <a:off x="6061862" y="1095583"/>
                      <a:ext cx="3066157" cy="2507922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3838945" y="974056"/>
                    <a:ext cx="1828800" cy="3030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b="1" dirty="0">
                        <a:latin typeface="Microsoft Sans Serif" panose="020B0604020202020204" pitchFamily="34" charset="0"/>
                        <a:ea typeface="Microsoft Sans Serif" panose="020B0604020202020204" pitchFamily="34" charset="0"/>
                        <a:cs typeface="Microsoft Sans Serif" panose="020B0604020202020204" pitchFamily="34" charset="0"/>
                      </a:rPr>
                      <a:t>Table beet</a:t>
                    </a:r>
                  </a:p>
                </p:txBody>
              </p:sp>
            </p:grpSp>
            <p:sp>
              <p:nvSpPr>
                <p:cNvPr id="15" name="TextBox 14"/>
                <p:cNvSpPr txBox="1"/>
                <p:nvPr/>
              </p:nvSpPr>
              <p:spPr>
                <a:xfrm>
                  <a:off x="848095" y="974056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Sugar beet</a:t>
                  </a: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9893437" y="972072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Leaf beet</a:t>
                  </a: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6980304" y="966397"/>
                  <a:ext cx="1828800" cy="303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Fodder beet</a:t>
                  </a:r>
                </a:p>
              </p:txBody>
            </p:sp>
          </p:grpSp>
          <p:sp>
            <p:nvSpPr>
              <p:cNvPr id="8" name="Rectangle 7"/>
              <p:cNvSpPr/>
              <p:nvPr/>
            </p:nvSpPr>
            <p:spPr>
              <a:xfrm>
                <a:off x="2619375" y="1200150"/>
                <a:ext cx="4749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5645020" y="1230437"/>
                <a:ext cx="4749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8682085" y="1220277"/>
                <a:ext cx="4749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11652232" y="1200150"/>
                <a:ext cx="474900" cy="8286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</p:grpSp>
        <p:sp>
          <p:nvSpPr>
            <p:cNvPr id="32" name="Rectangle 31"/>
            <p:cNvSpPr/>
            <p:nvPr/>
          </p:nvSpPr>
          <p:spPr>
            <a:xfrm>
              <a:off x="3213451" y="3970608"/>
              <a:ext cx="385856" cy="67329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/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689077" y="3818746"/>
              <a:ext cx="9016899" cy="2437675"/>
              <a:chOff x="1560381" y="3908686"/>
              <a:chExt cx="10385436" cy="2705192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DC364D3B-FA0D-A1B9-F0FE-62F3C84919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29966" t="69991" r="65661" b="20706"/>
              <a:stretch/>
            </p:blipFill>
            <p:spPr>
              <a:xfrm>
                <a:off x="10795136" y="4876456"/>
                <a:ext cx="1150681" cy="1737422"/>
              </a:xfrm>
              <a:prstGeom prst="rect">
                <a:avLst/>
              </a:prstGeom>
            </p:spPr>
          </p:pic>
          <p:grpSp>
            <p:nvGrpSpPr>
              <p:cNvPr id="11" name="Group 10"/>
              <p:cNvGrpSpPr/>
              <p:nvPr/>
            </p:nvGrpSpPr>
            <p:grpSpPr>
              <a:xfrm>
                <a:off x="1560381" y="3908686"/>
                <a:ext cx="9006227" cy="2659144"/>
                <a:chOff x="1560381" y="3908686"/>
                <a:chExt cx="9006227" cy="2659144"/>
              </a:xfrm>
            </p:grpSpPr>
            <p:grpSp>
              <p:nvGrpSpPr>
                <p:cNvPr id="27" name="Group 26"/>
                <p:cNvGrpSpPr/>
                <p:nvPr/>
              </p:nvGrpSpPr>
              <p:grpSpPr>
                <a:xfrm>
                  <a:off x="1560381" y="3908686"/>
                  <a:ext cx="9006227" cy="2659144"/>
                  <a:chOff x="1560381" y="3908686"/>
                  <a:chExt cx="9006227" cy="2659144"/>
                </a:xfrm>
              </p:grpSpPr>
              <p:pic>
                <p:nvPicPr>
                  <p:cNvPr id="9" name="Picture 8">
                    <a:extLst>
                      <a:ext uri="{FF2B5EF4-FFF2-40B4-BE49-F238E27FC236}">
                        <a16:creationId xmlns:a16="http://schemas.microsoft.com/office/drawing/2014/main" id="{DC364D3B-FA0D-A1B9-F0FE-62F3C849194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9814" t="69991" r="65661" b="1591"/>
                  <a:stretch/>
                </p:blipFill>
                <p:spPr>
                  <a:xfrm>
                    <a:off x="7629893" y="4152900"/>
                    <a:ext cx="2936715" cy="2414930"/>
                  </a:xfrm>
                  <a:prstGeom prst="rect">
                    <a:avLst/>
                  </a:prstGeom>
                </p:spPr>
              </p:pic>
              <p:grpSp>
                <p:nvGrpSpPr>
                  <p:cNvPr id="24" name="Group 23"/>
                  <p:cNvGrpSpPr/>
                  <p:nvPr/>
                </p:nvGrpSpPr>
                <p:grpSpPr>
                  <a:xfrm>
                    <a:off x="1560381" y="3922315"/>
                    <a:ext cx="6007836" cy="2645515"/>
                    <a:chOff x="-6398157" y="990167"/>
                    <a:chExt cx="6007836" cy="2645515"/>
                  </a:xfrm>
                </p:grpSpPr>
                <p:grpSp>
                  <p:nvGrpSpPr>
                    <p:cNvPr id="20" name="Group 19"/>
                    <p:cNvGrpSpPr/>
                    <p:nvPr/>
                  </p:nvGrpSpPr>
                  <p:grpSpPr>
                    <a:xfrm>
                      <a:off x="-6398157" y="1169720"/>
                      <a:ext cx="6007836" cy="2465962"/>
                      <a:chOff x="1622057" y="4107543"/>
                      <a:chExt cx="6007836" cy="2465962"/>
                    </a:xfrm>
                  </p:grpSpPr>
                  <p:pic>
                    <p:nvPicPr>
                      <p:cNvPr id="21" name="Picture 20">
                        <a:extLst>
                          <a:ext uri="{FF2B5EF4-FFF2-40B4-BE49-F238E27FC236}">
                            <a16:creationId xmlns:a16="http://schemas.microsoft.com/office/drawing/2014/main" id="{9D80C5B4-D087-6E50-7183-CDA410768A1D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" cstate="email"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</a:extLst>
                      </a:blip>
                      <a:srcRect l="36952" t="36763" r="37508" b="34844"/>
                      <a:stretch/>
                    </p:blipFill>
                    <p:spPr>
                      <a:xfrm>
                        <a:off x="1622057" y="4107543"/>
                        <a:ext cx="3067788" cy="2422446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2" name="Picture 21">
                        <a:extLst>
                          <a:ext uri="{FF2B5EF4-FFF2-40B4-BE49-F238E27FC236}">
                            <a16:creationId xmlns:a16="http://schemas.microsoft.com/office/drawing/2014/main" id="{08709C6D-B7C4-B064-420A-A8EFECA279B7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" cstate="email"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</a:extLst>
                      </a:blip>
                      <a:srcRect l="63506" t="37119" r="11969" b="34284"/>
                      <a:stretch/>
                    </p:blipFill>
                    <p:spPr>
                      <a:xfrm>
                        <a:off x="4689845" y="4150955"/>
                        <a:ext cx="2940048" cy="2422550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23" name="TextBox 22"/>
                    <p:cNvSpPr txBox="1"/>
                    <p:nvPr/>
                  </p:nvSpPr>
                  <p:spPr>
                    <a:xfrm>
                      <a:off x="-6123413" y="990167"/>
                      <a:ext cx="2552626" cy="30304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>
                      <a:defPPr>
                        <a:defRPr lang="en-US"/>
                      </a:defPPr>
                      <a:lvl1pPr algn="ctr">
                        <a:defRPr sz="650" b="1">
                          <a:latin typeface="Senif"/>
                        </a:defRPr>
                      </a:lvl1pPr>
                    </a:lstStyle>
                    <a:p>
                      <a:r>
                        <a:rPr lang="en-US" sz="1000" dirty="0">
                          <a:latin typeface="Microsoft Sans Serif" panose="020B0604020202020204" pitchFamily="34" charset="0"/>
                          <a:ea typeface="Microsoft Sans Serif" panose="020B0604020202020204" pitchFamily="34" charset="0"/>
                          <a:cs typeface="Microsoft Sans Serif" panose="020B0604020202020204" pitchFamily="34" charset="0"/>
                        </a:rPr>
                        <a:t>Mediterranean </a:t>
                      </a:r>
                      <a:r>
                        <a:rPr lang="en-GB" sz="1000" dirty="0">
                          <a:latin typeface="Microsoft Sans Serif" panose="020B0604020202020204" pitchFamily="34" charset="0"/>
                          <a:ea typeface="Microsoft Sans Serif" panose="020B0604020202020204" pitchFamily="34" charset="0"/>
                          <a:cs typeface="Microsoft Sans Serif" panose="020B0604020202020204" pitchFamily="34" charset="0"/>
                        </a:rPr>
                        <a:t>sea beet</a:t>
                      </a:r>
                      <a:endParaRPr lang="en-GB" sz="1000" i="1" dirty="0">
                        <a:latin typeface="Microsoft Sans Serif" panose="020B0604020202020204" pitchFamily="34" charset="0"/>
                        <a:ea typeface="Microsoft Sans Serif" panose="020B0604020202020204" pitchFamily="34" charset="0"/>
                        <a:cs typeface="Microsoft Sans Serif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8026400" y="3908686"/>
                    <a:ext cx="2540208" cy="3125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algn="ctr">
                      <a:defRPr sz="650" b="1">
                        <a:latin typeface="Senif"/>
                      </a:defRPr>
                    </a:lvl1pPr>
                  </a:lstStyle>
                  <a:p>
                    <a:r>
                      <a:rPr lang="en-GB" sz="1000" dirty="0">
                        <a:latin typeface="Microsoft Sans Serif" panose="020B0604020202020204" pitchFamily="34" charset="0"/>
                        <a:ea typeface="Microsoft Sans Serif" panose="020B0604020202020204" pitchFamily="34" charset="0"/>
                        <a:cs typeface="Microsoft Sans Serif" panose="020B0604020202020204" pitchFamily="34" charset="0"/>
                      </a:rPr>
                      <a:t>Diversity panel 245 samples</a:t>
                    </a:r>
                    <a:endParaRPr lang="en-GB" sz="1000" i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endParaRPr>
                  </a:p>
                </p:txBody>
              </p:sp>
            </p:grpSp>
            <p:sp>
              <p:nvSpPr>
                <p:cNvPr id="33" name="Rectangle 32"/>
                <p:cNvSpPr/>
                <p:nvPr/>
              </p:nvSpPr>
              <p:spPr>
                <a:xfrm>
                  <a:off x="7151214" y="4152900"/>
                  <a:ext cx="474900" cy="82867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463"/>
                </a:p>
              </p:txBody>
            </p:sp>
            <p:sp>
              <p:nvSpPr>
                <p:cNvPr id="34" name="Rectangle 33"/>
                <p:cNvSpPr/>
                <p:nvPr/>
              </p:nvSpPr>
              <p:spPr>
                <a:xfrm>
                  <a:off x="10084569" y="4152900"/>
                  <a:ext cx="474900" cy="82867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463"/>
                </a:p>
              </p:txBody>
            </p:sp>
            <p:sp>
              <p:nvSpPr>
                <p:cNvPr id="35" name="Rectangle 34"/>
                <p:cNvSpPr/>
                <p:nvPr/>
              </p:nvSpPr>
              <p:spPr>
                <a:xfrm>
                  <a:off x="3974859" y="4117352"/>
                  <a:ext cx="474900" cy="82867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463"/>
                </a:p>
              </p:txBody>
            </p:sp>
          </p:grpSp>
        </p:grpSp>
        <p:sp>
          <p:nvSpPr>
            <p:cNvPr id="36" name="TextBox 35"/>
            <p:cNvSpPr txBox="1"/>
            <p:nvPr/>
          </p:nvSpPr>
          <p:spPr>
            <a:xfrm>
              <a:off x="1102612" y="3380465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-28508" y="2284803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547174" y="3372493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2416054" y="2276831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067403" y="3371680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4936283" y="2276018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8451661" y="3389371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7298769" y="2293709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893401" y="5997875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473052" y="4768426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556933" y="5975659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3221969" y="4762696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099706" y="5999965"/>
              <a:ext cx="815936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 err="1"/>
                <a:t>Distance</a:t>
              </a:r>
              <a:r>
                <a:rPr lang="de-DE" sz="900" dirty="0"/>
                <a:t> (</a:t>
              </a:r>
              <a:r>
                <a:rPr lang="de-DE" sz="900" dirty="0" err="1"/>
                <a:t>kb</a:t>
              </a:r>
              <a:r>
                <a:rPr lang="de-DE" sz="900" dirty="0"/>
                <a:t>)</a:t>
              </a:r>
              <a:endParaRPr lang="en-GB" sz="900" dirty="0"/>
            </a:p>
          </p:txBody>
        </p:sp>
        <p:sp>
          <p:nvSpPr>
            <p:cNvPr id="49" name="TextBox 48"/>
            <p:cNvSpPr txBox="1"/>
            <p:nvPr/>
          </p:nvSpPr>
          <p:spPr>
            <a:xfrm rot="16200000">
              <a:off x="5835501" y="4787002"/>
              <a:ext cx="32495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dirty="0"/>
                <a:t>r</a:t>
              </a:r>
              <a:r>
                <a:rPr lang="de-DE" sz="1100" baseline="30000" dirty="0"/>
                <a:t>2</a:t>
              </a:r>
              <a:endParaRPr lang="en-GB" sz="1100" baseline="30000" dirty="0"/>
            </a:p>
          </p:txBody>
        </p:sp>
      </p:grpSp>
    </p:spTree>
    <p:extLst>
      <p:ext uri="{BB962C8B-B14F-4D97-AF65-F5344CB8AC3E}">
        <p14:creationId xmlns:p14="http://schemas.microsoft.com/office/powerpoint/2010/main" val="18589871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0641685"/>
              </p:ext>
            </p:extLst>
          </p:nvPr>
        </p:nvGraphicFramePr>
        <p:xfrm>
          <a:off x="6780827" y="1176933"/>
          <a:ext cx="2767772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4315833"/>
              </p:ext>
            </p:extLst>
          </p:nvPr>
        </p:nvGraphicFramePr>
        <p:xfrm>
          <a:off x="3605831" y="3429001"/>
          <a:ext cx="2767772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3416491"/>
              </p:ext>
            </p:extLst>
          </p:nvPr>
        </p:nvGraphicFramePr>
        <p:xfrm>
          <a:off x="3605831" y="1176933"/>
          <a:ext cx="2767772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2409499"/>
              </p:ext>
            </p:extLst>
          </p:nvPr>
        </p:nvGraphicFramePr>
        <p:xfrm>
          <a:off x="430835" y="1180148"/>
          <a:ext cx="2767772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0499271"/>
              </p:ext>
            </p:extLst>
          </p:nvPr>
        </p:nvGraphicFramePr>
        <p:xfrm>
          <a:off x="6780826" y="3429001"/>
          <a:ext cx="2771131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1410680"/>
              </p:ext>
            </p:extLst>
          </p:nvPr>
        </p:nvGraphicFramePr>
        <p:xfrm>
          <a:off x="430835" y="3429001"/>
          <a:ext cx="2767772" cy="18900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21" name="Group 20"/>
          <p:cNvGrpSpPr/>
          <p:nvPr/>
        </p:nvGrpSpPr>
        <p:grpSpPr>
          <a:xfrm>
            <a:off x="2552487" y="5565109"/>
            <a:ext cx="4874460" cy="246682"/>
            <a:chOff x="2495551" y="6061709"/>
            <a:chExt cx="5999334" cy="303608"/>
          </a:xfrm>
        </p:grpSpPr>
        <p:sp>
          <p:nvSpPr>
            <p:cNvPr id="9" name="Rectangle 8"/>
            <p:cNvSpPr/>
            <p:nvPr/>
          </p:nvSpPr>
          <p:spPr>
            <a:xfrm>
              <a:off x="2495551" y="6096806"/>
              <a:ext cx="216694" cy="21588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3489485" y="6092831"/>
              <a:ext cx="216694" cy="21588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483419" y="6092831"/>
              <a:ext cx="216694" cy="215888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477353" y="6092830"/>
              <a:ext cx="216694" cy="215888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6485579" y="6092830"/>
              <a:ext cx="216694" cy="215888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7493805" y="6092830"/>
              <a:ext cx="216694" cy="215888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712246" y="6062276"/>
              <a:ext cx="777240" cy="303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-10%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706178" y="6062276"/>
              <a:ext cx="777240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0-15%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703685" y="6062276"/>
              <a:ext cx="777240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5-20%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701193" y="6062276"/>
              <a:ext cx="777240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0-25%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709420" y="6061709"/>
              <a:ext cx="777240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5-30%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717645" y="6061709"/>
              <a:ext cx="777240" cy="30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0-35%</a:t>
              </a:r>
            </a:p>
          </p:txBody>
        </p:sp>
      </p:grpSp>
      <p:sp>
        <p:nvSpPr>
          <p:cNvPr id="22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32657" y="83452"/>
            <a:ext cx="67358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Fig. S7</a:t>
            </a:r>
          </a:p>
        </p:txBody>
      </p:sp>
    </p:spTree>
    <p:extLst>
      <p:ext uri="{BB962C8B-B14F-4D97-AF65-F5344CB8AC3E}">
        <p14:creationId xmlns:p14="http://schemas.microsoft.com/office/powerpoint/2010/main" val="35598453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67124"/>
            <a:ext cx="9670720" cy="6147939"/>
            <a:chOff x="0" y="67124"/>
            <a:chExt cx="9670720" cy="6147939"/>
          </a:xfrm>
        </p:grpSpPr>
        <p:sp>
          <p:nvSpPr>
            <p:cNvPr id="11" name="Textfeld 34">
              <a:extLst>
                <a:ext uri="{FF2B5EF4-FFF2-40B4-BE49-F238E27FC236}">
                  <a16:creationId xmlns:a16="http://schemas.microsoft.com/office/drawing/2014/main" id="{41E97575-BAB2-3D65-1E10-0331810EF907}"/>
                </a:ext>
              </a:extLst>
            </p:cNvPr>
            <p:cNvSpPr txBox="1"/>
            <p:nvPr/>
          </p:nvSpPr>
          <p:spPr>
            <a:xfrm>
              <a:off x="0" y="67124"/>
              <a:ext cx="67358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63" dirty="0"/>
                <a:t>Fig. S8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>
              <a:alphaModFix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contrast="74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49297" y="919847"/>
              <a:ext cx="9421423" cy="5295216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 rot="16200000">
              <a:off x="-38956" y="1598865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/>
                <a:t>XP-CLR</a:t>
              </a:r>
              <a:endParaRPr lang="en-GB" sz="900" baseline="30000" dirty="0"/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3123344" y="1598866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/>
                <a:t>XP-CLR</a:t>
              </a:r>
              <a:endParaRPr lang="en-GB" sz="900" baseline="30000" dirty="0"/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6224701" y="1598865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/>
                <a:t>XP-CLR0</a:t>
              </a:r>
              <a:endParaRPr lang="en-GB" sz="900" baseline="30000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-38957" y="3324252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/>
                <a:t>XP-CLR</a:t>
              </a:r>
              <a:endParaRPr lang="en-GB" sz="900" baseline="30000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3117901" y="3324252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/>
                <a:t>XP-CLR</a:t>
              </a:r>
              <a:endParaRPr lang="en-GB" sz="900" baseline="300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6274759" y="3324253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/>
                <a:t>XP-CLR</a:t>
              </a:r>
              <a:endParaRPr lang="en-GB" sz="900" baseline="30000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-38958" y="5131280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/>
                <a:t>XP-CLR</a:t>
              </a:r>
              <a:endParaRPr lang="en-GB" sz="900" baseline="30000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3117900" y="5131280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/>
                <a:t>XP-CLR</a:t>
              </a:r>
              <a:endParaRPr lang="en-GB" sz="900" baseline="30000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6230186" y="5131280"/>
              <a:ext cx="5765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900" dirty="0"/>
                <a:t>XP-CLR</a:t>
              </a:r>
              <a:endParaRPr lang="en-GB" sz="900" baseline="30000" dirty="0"/>
            </a:p>
          </p:txBody>
        </p:sp>
      </p:grpSp>
    </p:spTree>
    <p:extLst>
      <p:ext uri="{BB962C8B-B14F-4D97-AF65-F5344CB8AC3E}">
        <p14:creationId xmlns:p14="http://schemas.microsoft.com/office/powerpoint/2010/main" val="14358482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34">
            <a:extLst>
              <a:ext uri="{FF2B5EF4-FFF2-40B4-BE49-F238E27FC236}">
                <a16:creationId xmlns:a16="http://schemas.microsoft.com/office/drawing/2014/main" id="{41E97575-BAB2-3D65-1E10-0331810EF907}"/>
              </a:ext>
            </a:extLst>
          </p:cNvPr>
          <p:cNvSpPr txBox="1"/>
          <p:nvPr/>
        </p:nvSpPr>
        <p:spPr>
          <a:xfrm>
            <a:off x="65314" y="95699"/>
            <a:ext cx="67358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/>
              <a:t>Fig. S9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alphaModFix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6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4859" y="895080"/>
            <a:ext cx="9436283" cy="531998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-457416" y="1471938"/>
            <a:ext cx="138454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/>
              <a:t>Weir and </a:t>
            </a:r>
            <a:r>
              <a:rPr lang="de-DE" sz="900" dirty="0" err="1"/>
              <a:t>Cockerham</a:t>
            </a:r>
            <a:r>
              <a:rPr lang="de-DE" sz="900" dirty="0"/>
              <a:t> F</a:t>
            </a:r>
            <a:r>
              <a:rPr lang="de-DE" sz="900" baseline="-25000" dirty="0"/>
              <a:t>ST</a:t>
            </a:r>
            <a:endParaRPr lang="en-GB" sz="900" baseline="-25000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2645838" y="1457048"/>
            <a:ext cx="1438831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/>
              <a:t>Weir and </a:t>
            </a:r>
            <a:r>
              <a:rPr lang="de-DE" sz="900" dirty="0" err="1"/>
              <a:t>Cockerham</a:t>
            </a:r>
            <a:r>
              <a:rPr lang="de-DE" sz="900" dirty="0"/>
              <a:t> F</a:t>
            </a:r>
            <a:r>
              <a:rPr lang="de-DE" sz="900" baseline="-25000" dirty="0"/>
              <a:t>ST</a:t>
            </a:r>
            <a:endParaRPr lang="en-GB" sz="900" i="1" baseline="-25000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5854745" y="1471938"/>
            <a:ext cx="134645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/>
              <a:t>Weir and </a:t>
            </a:r>
            <a:r>
              <a:rPr lang="de-DE" sz="900" dirty="0" err="1"/>
              <a:t>Cockerham</a:t>
            </a:r>
            <a:r>
              <a:rPr lang="de-DE" sz="900" dirty="0"/>
              <a:t> F</a:t>
            </a:r>
            <a:r>
              <a:rPr lang="de-DE" sz="900" baseline="-25000" dirty="0"/>
              <a:t>ST</a:t>
            </a:r>
            <a:endParaRPr lang="en-GB" sz="900" i="1" baseline="-25000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-436769" y="3318461"/>
            <a:ext cx="1343254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/>
              <a:t>Weir and </a:t>
            </a:r>
            <a:r>
              <a:rPr lang="de-DE" sz="900" dirty="0" err="1"/>
              <a:t>Cockerham</a:t>
            </a:r>
            <a:r>
              <a:rPr lang="de-DE" sz="900" dirty="0"/>
              <a:t> F</a:t>
            </a:r>
            <a:r>
              <a:rPr lang="de-DE" sz="900" baseline="-25000" dirty="0"/>
              <a:t>ST</a:t>
            </a:r>
            <a:endParaRPr lang="en-GB" sz="900" i="1" baseline="-250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2646854" y="3204908"/>
            <a:ext cx="1439998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/>
              <a:t>Weir and </a:t>
            </a:r>
            <a:r>
              <a:rPr lang="de-DE" sz="900" dirty="0" err="1"/>
              <a:t>Cockerham</a:t>
            </a:r>
            <a:r>
              <a:rPr lang="de-DE" sz="900" dirty="0"/>
              <a:t> F</a:t>
            </a:r>
            <a:r>
              <a:rPr lang="de-DE" sz="900" baseline="-25000" dirty="0"/>
              <a:t>ST</a:t>
            </a:r>
            <a:endParaRPr lang="en-GB" sz="900" i="1" baseline="-250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5825921" y="3263156"/>
            <a:ext cx="1404097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/>
              <a:t>Weir and </a:t>
            </a:r>
            <a:r>
              <a:rPr lang="de-DE" sz="900" dirty="0" err="1"/>
              <a:t>Cockerham</a:t>
            </a:r>
            <a:r>
              <a:rPr lang="de-DE" sz="900" dirty="0"/>
              <a:t> F</a:t>
            </a:r>
            <a:r>
              <a:rPr lang="de-DE" sz="900" baseline="-25000" dirty="0"/>
              <a:t>ST</a:t>
            </a:r>
            <a:endParaRPr lang="en-GB" sz="900" i="1" baseline="-250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-433545" y="5080640"/>
            <a:ext cx="132508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/>
              <a:t>Weir and </a:t>
            </a:r>
            <a:r>
              <a:rPr lang="de-DE" sz="900" dirty="0" err="1"/>
              <a:t>Cockerham</a:t>
            </a:r>
            <a:r>
              <a:rPr lang="de-DE" sz="900" dirty="0"/>
              <a:t> F</a:t>
            </a:r>
            <a:r>
              <a:rPr lang="de-DE" sz="900" baseline="-25000" dirty="0"/>
              <a:t>ST</a:t>
            </a:r>
            <a:endParaRPr lang="en-GB" sz="900" i="1" baseline="-250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2679094" y="5057019"/>
            <a:ext cx="137232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/>
              <a:t>Weir and </a:t>
            </a:r>
            <a:r>
              <a:rPr lang="de-DE" sz="900" dirty="0" err="1"/>
              <a:t>Cockerham</a:t>
            </a:r>
            <a:r>
              <a:rPr lang="de-DE" sz="900" dirty="0"/>
              <a:t> F</a:t>
            </a:r>
            <a:r>
              <a:rPr lang="de-DE" sz="900" baseline="-25000" dirty="0"/>
              <a:t>ST</a:t>
            </a:r>
            <a:endParaRPr lang="en-GB" sz="900" i="1" baseline="-250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5801973" y="5090544"/>
            <a:ext cx="1418128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900" dirty="0"/>
              <a:t>Weir and </a:t>
            </a:r>
            <a:r>
              <a:rPr lang="de-DE" sz="900" dirty="0" err="1"/>
              <a:t>Cockerham</a:t>
            </a:r>
            <a:r>
              <a:rPr lang="de-DE" sz="900" dirty="0"/>
              <a:t> F</a:t>
            </a:r>
            <a:r>
              <a:rPr lang="de-DE" sz="900" baseline="-25000" dirty="0"/>
              <a:t>ST</a:t>
            </a:r>
            <a:endParaRPr lang="en-GB" sz="900" i="1" baseline="-25000" dirty="0"/>
          </a:p>
        </p:txBody>
      </p:sp>
    </p:spTree>
    <p:extLst>
      <p:ext uri="{BB962C8B-B14F-4D97-AF65-F5344CB8AC3E}">
        <p14:creationId xmlns:p14="http://schemas.microsoft.com/office/powerpoint/2010/main" val="137961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– 2022-Design">
  <a:themeElements>
    <a:clrScheme name="Office 2013 – 2022-Design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– 2022-Design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– 2022-Design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428</Words>
  <Application>Microsoft Office PowerPoint</Application>
  <PresentationFormat>A4 Paper (210x297 mm)</PresentationFormat>
  <Paragraphs>171</Paragraphs>
  <Slides>1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9" baseType="lpstr">
      <vt:lpstr>Arial</vt:lpstr>
      <vt:lpstr>Calibri</vt:lpstr>
      <vt:lpstr>Calibri Light</vt:lpstr>
      <vt:lpstr>Microsoft Sans Serif</vt:lpstr>
      <vt:lpstr>Sanf</vt:lpstr>
      <vt:lpstr>Office 2013 – 2022-Desig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rsingh dhiman</dc:creator>
  <cp:lastModifiedBy>Nazgol Emrani</cp:lastModifiedBy>
  <cp:revision>87</cp:revision>
  <dcterms:created xsi:type="dcterms:W3CDTF">2023-09-03T15:39:25Z</dcterms:created>
  <dcterms:modified xsi:type="dcterms:W3CDTF">2025-09-18T08:34:00Z</dcterms:modified>
</cp:coreProperties>
</file>